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65" r:id="rId4"/>
    <p:sldId id="266" r:id="rId5"/>
    <p:sldId id="267" r:id="rId6"/>
    <p:sldId id="268" r:id="rId7"/>
    <p:sldId id="259" r:id="rId8"/>
    <p:sldId id="260" r:id="rId9"/>
    <p:sldId id="262" r:id="rId10"/>
    <p:sldId id="263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>
          <p15:clr>
            <a:srgbClr val="A4A3A4"/>
          </p15:clr>
        </p15:guide>
        <p15:guide id="3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BD556D2-A6D4-4846-A83E-4B1AF0FE44F2}" v="32" dt="2025-07-24T19:40:36.43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286"/>
  </p:normalViewPr>
  <p:slideViewPr>
    <p:cSldViewPr snapToGrid="0" showGuides="1">
      <p:cViewPr varScale="1">
        <p:scale>
          <a:sx n="120" d="100"/>
          <a:sy n="120" d="100"/>
        </p:scale>
        <p:origin x="800" y="192"/>
      </p:cViewPr>
      <p:guideLst>
        <p:guide pos="3840"/>
        <p:guide orient="horz"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iming Xu" userId="e18c41139f0e09dd" providerId="LiveId" clId="{44F259A5-9597-CA4C-8A3C-A4588364E2AF}"/>
    <pc:docChg chg="undo redo custSel addSld delSld modSld sldOrd">
      <pc:chgData name="Caiming Xu" userId="e18c41139f0e09dd" providerId="LiveId" clId="{44F259A5-9597-CA4C-8A3C-A4588364E2AF}" dt="2025-06-19T07:08:52.072" v="1797" actId="1038"/>
      <pc:docMkLst>
        <pc:docMk/>
      </pc:docMkLst>
      <pc:sldChg chg="addSp delSp modSp add del mod">
        <pc:chgData name="Caiming Xu" userId="e18c41139f0e09dd" providerId="LiveId" clId="{44F259A5-9597-CA4C-8A3C-A4588364E2AF}" dt="2025-06-11T01:34:48.364" v="68" actId="2696"/>
        <pc:sldMkLst>
          <pc:docMk/>
          <pc:sldMk cId="2132240086" sldId="256"/>
        </pc:sldMkLst>
      </pc:sldChg>
      <pc:sldChg chg="del">
        <pc:chgData name="Caiming Xu" userId="e18c41139f0e09dd" providerId="LiveId" clId="{44F259A5-9597-CA4C-8A3C-A4588364E2AF}" dt="2025-06-11T00:41:37.238" v="26" actId="2696"/>
        <pc:sldMkLst>
          <pc:docMk/>
          <pc:sldMk cId="1450741610" sldId="257"/>
        </pc:sldMkLst>
      </pc:sldChg>
      <pc:sldChg chg="addSp delSp modSp add mod">
        <pc:chgData name="Caiming Xu" userId="e18c41139f0e09dd" providerId="LiveId" clId="{44F259A5-9597-CA4C-8A3C-A4588364E2AF}" dt="2025-06-19T06:47:05.602" v="1474" actId="14100"/>
        <pc:sldMkLst>
          <pc:docMk/>
          <pc:sldMk cId="4192924268" sldId="257"/>
        </pc:sldMkLst>
      </pc:sldChg>
      <pc:sldChg chg="addSp delSp modSp add mod">
        <pc:chgData name="Caiming Xu" userId="e18c41139f0e09dd" providerId="LiveId" clId="{44F259A5-9597-CA4C-8A3C-A4588364E2AF}" dt="2025-06-19T06:44:51.231" v="1472"/>
        <pc:sldMkLst>
          <pc:docMk/>
          <pc:sldMk cId="907731770" sldId="258"/>
        </pc:sldMkLst>
      </pc:sldChg>
      <pc:sldChg chg="del">
        <pc:chgData name="Caiming Xu" userId="e18c41139f0e09dd" providerId="LiveId" clId="{44F259A5-9597-CA4C-8A3C-A4588364E2AF}" dt="2025-06-11T00:41:37.982" v="28" actId="2696"/>
        <pc:sldMkLst>
          <pc:docMk/>
          <pc:sldMk cId="3527795092" sldId="258"/>
        </pc:sldMkLst>
      </pc:sldChg>
      <pc:sldChg chg="del">
        <pc:chgData name="Caiming Xu" userId="e18c41139f0e09dd" providerId="LiveId" clId="{44F259A5-9597-CA4C-8A3C-A4588364E2AF}" dt="2025-06-11T00:41:37.623" v="27" actId="2696"/>
        <pc:sldMkLst>
          <pc:docMk/>
          <pc:sldMk cId="841826548" sldId="259"/>
        </pc:sldMkLst>
      </pc:sldChg>
      <pc:sldChg chg="addSp delSp modSp add mod">
        <pc:chgData name="Caiming Xu" userId="e18c41139f0e09dd" providerId="LiveId" clId="{44F259A5-9597-CA4C-8A3C-A4588364E2AF}" dt="2025-06-11T02:26:44.471" v="624" actId="20577"/>
        <pc:sldMkLst>
          <pc:docMk/>
          <pc:sldMk cId="1770512079" sldId="259"/>
        </pc:sldMkLst>
      </pc:sldChg>
      <pc:sldChg chg="addSp delSp modSp add del mod">
        <pc:chgData name="Caiming Xu" userId="e18c41139f0e09dd" providerId="LiveId" clId="{44F259A5-9597-CA4C-8A3C-A4588364E2AF}" dt="2025-06-19T06:48:21.151" v="1478" actId="2696"/>
        <pc:sldMkLst>
          <pc:docMk/>
          <pc:sldMk cId="3156754182" sldId="260"/>
        </pc:sldMkLst>
      </pc:sldChg>
      <pc:sldChg chg="del">
        <pc:chgData name="Caiming Xu" userId="e18c41139f0e09dd" providerId="LiveId" clId="{44F259A5-9597-CA4C-8A3C-A4588364E2AF}" dt="2025-06-11T00:41:39.038" v="31" actId="2696"/>
        <pc:sldMkLst>
          <pc:docMk/>
          <pc:sldMk cId="3928639220" sldId="260"/>
        </pc:sldMkLst>
      </pc:sldChg>
      <pc:sldChg chg="del">
        <pc:chgData name="Caiming Xu" userId="e18c41139f0e09dd" providerId="LiveId" clId="{44F259A5-9597-CA4C-8A3C-A4588364E2AF}" dt="2025-06-11T00:41:39.441" v="32" actId="2696"/>
        <pc:sldMkLst>
          <pc:docMk/>
          <pc:sldMk cId="89749538" sldId="261"/>
        </pc:sldMkLst>
      </pc:sldChg>
      <pc:sldChg chg="addSp delSp modSp add del mod">
        <pc:chgData name="Caiming Xu" userId="e18c41139f0e09dd" providerId="LiveId" clId="{44F259A5-9597-CA4C-8A3C-A4588364E2AF}" dt="2025-06-19T06:48:17.289" v="1476" actId="2696"/>
        <pc:sldMkLst>
          <pc:docMk/>
          <pc:sldMk cId="3596000678" sldId="261"/>
        </pc:sldMkLst>
      </pc:sldChg>
      <pc:sldChg chg="del">
        <pc:chgData name="Caiming Xu" userId="e18c41139f0e09dd" providerId="LiveId" clId="{44F259A5-9597-CA4C-8A3C-A4588364E2AF}" dt="2025-06-11T00:41:38.350" v="29" actId="2696"/>
        <pc:sldMkLst>
          <pc:docMk/>
          <pc:sldMk cId="2035111799" sldId="262"/>
        </pc:sldMkLst>
      </pc:sldChg>
      <pc:sldChg chg="addSp delSp modSp add mod ord">
        <pc:chgData name="Caiming Xu" userId="e18c41139f0e09dd" providerId="LiveId" clId="{44F259A5-9597-CA4C-8A3C-A4588364E2AF}" dt="2025-06-19T06:58:30.090" v="1648" actId="20578"/>
        <pc:sldMkLst>
          <pc:docMk/>
          <pc:sldMk cId="3074413206" sldId="262"/>
        </pc:sldMkLst>
      </pc:sldChg>
      <pc:sldChg chg="del">
        <pc:chgData name="Caiming Xu" userId="e18c41139f0e09dd" providerId="LiveId" clId="{44F259A5-9597-CA4C-8A3C-A4588364E2AF}" dt="2025-06-11T00:41:38.717" v="30" actId="2696"/>
        <pc:sldMkLst>
          <pc:docMk/>
          <pc:sldMk cId="435785349" sldId="263"/>
        </pc:sldMkLst>
      </pc:sldChg>
      <pc:sldChg chg="addSp delSp modSp add mod ord">
        <pc:chgData name="Caiming Xu" userId="e18c41139f0e09dd" providerId="LiveId" clId="{44F259A5-9597-CA4C-8A3C-A4588364E2AF}" dt="2025-06-19T06:58:30.090" v="1648" actId="20578"/>
        <pc:sldMkLst>
          <pc:docMk/>
          <pc:sldMk cId="3110685640" sldId="263"/>
        </pc:sldMkLst>
      </pc:sldChg>
      <pc:sldChg chg="addSp delSp modSp add del mod">
        <pc:chgData name="Caiming Xu" userId="e18c41139f0e09dd" providerId="LiveId" clId="{44F259A5-9597-CA4C-8A3C-A4588364E2AF}" dt="2025-06-19T06:48:24.581" v="1479" actId="2696"/>
        <pc:sldMkLst>
          <pc:docMk/>
          <pc:sldMk cId="3653625724" sldId="264"/>
        </pc:sldMkLst>
      </pc:sldChg>
      <pc:sldChg chg="addSp delSp modSp add mod ord">
        <pc:chgData name="Caiming Xu" userId="e18c41139f0e09dd" providerId="LiveId" clId="{44F259A5-9597-CA4C-8A3C-A4588364E2AF}" dt="2025-06-19T07:07:57.616" v="1763" actId="20577"/>
        <pc:sldMkLst>
          <pc:docMk/>
          <pc:sldMk cId="1445140296" sldId="265"/>
        </pc:sldMkLst>
      </pc:sldChg>
      <pc:sldChg chg="add del">
        <pc:chgData name="Caiming Xu" userId="e18c41139f0e09dd" providerId="LiveId" clId="{44F259A5-9597-CA4C-8A3C-A4588364E2AF}" dt="2025-06-17T06:22:21.324" v="1279"/>
        <pc:sldMkLst>
          <pc:docMk/>
          <pc:sldMk cId="2240014202" sldId="265"/>
        </pc:sldMkLst>
      </pc:sldChg>
      <pc:sldChg chg="addSp delSp modSp add mod ord">
        <pc:chgData name="Caiming Xu" userId="e18c41139f0e09dd" providerId="LiveId" clId="{44F259A5-9597-CA4C-8A3C-A4588364E2AF}" dt="2025-06-19T07:08:52.072" v="1797" actId="1038"/>
        <pc:sldMkLst>
          <pc:docMk/>
          <pc:sldMk cId="2994768025" sldId="266"/>
        </pc:sldMkLst>
      </pc:sldChg>
    </pc:docChg>
  </pc:docChgLst>
  <pc:docChgLst>
    <pc:chgData name="Caiming Xu" userId="e18c41139f0e09dd" providerId="LiveId" clId="{DBD556D2-A6D4-4846-A83E-4B1AF0FE44F2}"/>
    <pc:docChg chg="undo custSel addSld modSld sldOrd">
      <pc:chgData name="Caiming Xu" userId="e18c41139f0e09dd" providerId="LiveId" clId="{DBD556D2-A6D4-4846-A83E-4B1AF0FE44F2}" dt="2025-07-26T23:38:22.823" v="434" actId="20578"/>
      <pc:docMkLst>
        <pc:docMk/>
      </pc:docMkLst>
      <pc:sldChg chg="modSp mod">
        <pc:chgData name="Caiming Xu" userId="e18c41139f0e09dd" providerId="LiveId" clId="{DBD556D2-A6D4-4846-A83E-4B1AF0FE44F2}" dt="2025-07-24T19:19:25.684" v="340" actId="166"/>
        <pc:sldMkLst>
          <pc:docMk/>
          <pc:sldMk cId="907731770" sldId="258"/>
        </pc:sldMkLst>
        <pc:spChg chg="mod">
          <ac:chgData name="Caiming Xu" userId="e18c41139f0e09dd" providerId="LiveId" clId="{DBD556D2-A6D4-4846-A83E-4B1AF0FE44F2}" dt="2025-07-24T19:19:25.684" v="340" actId="166"/>
          <ac:spMkLst>
            <pc:docMk/>
            <pc:sldMk cId="907731770" sldId="258"/>
            <ac:spMk id="20" creationId="{A7EB8CA3-C34D-CFC2-484A-DBB6E00B40D3}"/>
          </ac:spMkLst>
        </pc:spChg>
      </pc:sldChg>
      <pc:sldChg chg="addSp delSp modSp mod">
        <pc:chgData name="Caiming Xu" userId="e18c41139f0e09dd" providerId="LiveId" clId="{DBD556D2-A6D4-4846-A83E-4B1AF0FE44F2}" dt="2025-07-24T19:38:10.609" v="397" actId="478"/>
        <pc:sldMkLst>
          <pc:docMk/>
          <pc:sldMk cId="3074413206" sldId="262"/>
        </pc:sldMkLst>
      </pc:sldChg>
      <pc:sldChg chg="addSp delSp modSp add mod ord">
        <pc:chgData name="Caiming Xu" userId="e18c41139f0e09dd" providerId="LiveId" clId="{DBD556D2-A6D4-4846-A83E-4B1AF0FE44F2}" dt="2025-07-26T23:38:22.823" v="434" actId="20578"/>
        <pc:sldMkLst>
          <pc:docMk/>
          <pc:sldMk cId="2669033645" sldId="267"/>
        </pc:sldMkLst>
        <pc:spChg chg="mod">
          <ac:chgData name="Caiming Xu" userId="e18c41139f0e09dd" providerId="LiveId" clId="{DBD556D2-A6D4-4846-A83E-4B1AF0FE44F2}" dt="2025-07-24T19:40:53.818" v="423" actId="1076"/>
          <ac:spMkLst>
            <pc:docMk/>
            <pc:sldMk cId="2669033645" sldId="267"/>
            <ac:spMk id="7" creationId="{0A3BE1F3-8EE0-66AB-5DD8-F3C66BA4DFA6}"/>
          </ac:spMkLst>
        </pc:spChg>
        <pc:spChg chg="mod">
          <ac:chgData name="Caiming Xu" userId="e18c41139f0e09dd" providerId="LiveId" clId="{DBD556D2-A6D4-4846-A83E-4B1AF0FE44F2}" dt="2025-07-24T19:40:53.818" v="423" actId="1076"/>
          <ac:spMkLst>
            <pc:docMk/>
            <pc:sldMk cId="2669033645" sldId="267"/>
            <ac:spMk id="8" creationId="{85604CC6-AA48-5500-FE0E-7B7EAB3787B8}"/>
          </ac:spMkLst>
        </pc:spChg>
        <pc:spChg chg="mod">
          <ac:chgData name="Caiming Xu" userId="e18c41139f0e09dd" providerId="LiveId" clId="{DBD556D2-A6D4-4846-A83E-4B1AF0FE44F2}" dt="2025-07-13T05:51:06.167" v="152" actId="554"/>
          <ac:spMkLst>
            <pc:docMk/>
            <pc:sldMk cId="2669033645" sldId="267"/>
            <ac:spMk id="9" creationId="{64F38E07-6BE8-3543-9EE5-BA9AD76B5E60}"/>
          </ac:spMkLst>
        </pc:spChg>
        <pc:spChg chg="mod">
          <ac:chgData name="Caiming Xu" userId="e18c41139f0e09dd" providerId="LiveId" clId="{DBD556D2-A6D4-4846-A83E-4B1AF0FE44F2}" dt="2025-07-24T19:40:53.818" v="423" actId="1076"/>
          <ac:spMkLst>
            <pc:docMk/>
            <pc:sldMk cId="2669033645" sldId="267"/>
            <ac:spMk id="12" creationId="{49EB9BDF-79D9-2BD9-C510-CCD59851F3E1}"/>
          </ac:spMkLst>
        </pc:spChg>
        <pc:spChg chg="mod">
          <ac:chgData name="Caiming Xu" userId="e18c41139f0e09dd" providerId="LiveId" clId="{DBD556D2-A6D4-4846-A83E-4B1AF0FE44F2}" dt="2025-07-24T19:24:33.992" v="358" actId="20577"/>
          <ac:spMkLst>
            <pc:docMk/>
            <pc:sldMk cId="2669033645" sldId="267"/>
            <ac:spMk id="13" creationId="{771288AB-A744-509E-8236-77D84A0AF0DD}"/>
          </ac:spMkLst>
        </pc:spChg>
        <pc:spChg chg="mod">
          <ac:chgData name="Caiming Xu" userId="e18c41139f0e09dd" providerId="LiveId" clId="{DBD556D2-A6D4-4846-A83E-4B1AF0FE44F2}" dt="2025-07-24T19:40:53.818" v="423" actId="1076"/>
          <ac:spMkLst>
            <pc:docMk/>
            <pc:sldMk cId="2669033645" sldId="267"/>
            <ac:spMk id="16" creationId="{AA146794-0E30-8E17-C558-CEB1E5A3F890}"/>
          </ac:spMkLst>
        </pc:spChg>
        <pc:spChg chg="mod">
          <ac:chgData name="Caiming Xu" userId="e18c41139f0e09dd" providerId="LiveId" clId="{DBD556D2-A6D4-4846-A83E-4B1AF0FE44F2}" dt="2025-07-24T19:40:53.818" v="423" actId="1076"/>
          <ac:spMkLst>
            <pc:docMk/>
            <pc:sldMk cId="2669033645" sldId="267"/>
            <ac:spMk id="19" creationId="{D31B40D4-E999-79BB-3260-557F7CB3EA45}"/>
          </ac:spMkLst>
        </pc:spChg>
        <pc:spChg chg="mod">
          <ac:chgData name="Caiming Xu" userId="e18c41139f0e09dd" providerId="LiveId" clId="{DBD556D2-A6D4-4846-A83E-4B1AF0FE44F2}" dt="2025-07-13T05:51:06.167" v="152" actId="554"/>
          <ac:spMkLst>
            <pc:docMk/>
            <pc:sldMk cId="2669033645" sldId="267"/>
            <ac:spMk id="20" creationId="{3A0E4530-D369-CF40-5E4C-9B55998D98E4}"/>
          </ac:spMkLst>
        </pc:spChg>
        <pc:spChg chg="mod">
          <ac:chgData name="Caiming Xu" userId="e18c41139f0e09dd" providerId="LiveId" clId="{DBD556D2-A6D4-4846-A83E-4B1AF0FE44F2}" dt="2025-07-24T19:40:53.818" v="423" actId="1076"/>
          <ac:spMkLst>
            <pc:docMk/>
            <pc:sldMk cId="2669033645" sldId="267"/>
            <ac:spMk id="37" creationId="{E2BE837F-8FD2-31F1-7AB3-0117F2DA4829}"/>
          </ac:spMkLst>
        </pc:spChg>
        <pc:grpChg chg="mod">
          <ac:chgData name="Caiming Xu" userId="e18c41139f0e09dd" providerId="LiveId" clId="{DBD556D2-A6D4-4846-A83E-4B1AF0FE44F2}" dt="2025-07-24T19:40:53.818" v="423" actId="1076"/>
          <ac:grpSpMkLst>
            <pc:docMk/>
            <pc:sldMk cId="2669033645" sldId="267"/>
            <ac:grpSpMk id="21" creationId="{6C02E667-D343-377B-B8F9-0F61C76B4B32}"/>
          </ac:grpSpMkLst>
        </pc:grpChg>
        <pc:grpChg chg="mod">
          <ac:chgData name="Caiming Xu" userId="e18c41139f0e09dd" providerId="LiveId" clId="{DBD556D2-A6D4-4846-A83E-4B1AF0FE44F2}" dt="2025-07-13T05:50:58.384" v="145" actId="1036"/>
          <ac:grpSpMkLst>
            <pc:docMk/>
            <pc:sldMk cId="2669033645" sldId="267"/>
            <ac:grpSpMk id="27" creationId="{4DD4B975-A269-8ACB-8ED7-584F0131FC1B}"/>
          </ac:grpSpMkLst>
        </pc:grpChg>
        <pc:picChg chg="add mod modCrop">
          <ac:chgData name="Caiming Xu" userId="e18c41139f0e09dd" providerId="LiveId" clId="{DBD556D2-A6D4-4846-A83E-4B1AF0FE44F2}" dt="2025-07-24T19:40:53.818" v="423" actId="1076"/>
          <ac:picMkLst>
            <pc:docMk/>
            <pc:sldMk cId="2669033645" sldId="267"/>
            <ac:picMk id="2" creationId="{700E1768-5A71-5164-A784-9EB231CE7D12}"/>
          </ac:picMkLst>
        </pc:picChg>
        <pc:picChg chg="add mod modCrop">
          <ac:chgData name="Caiming Xu" userId="e18c41139f0e09dd" providerId="LiveId" clId="{DBD556D2-A6D4-4846-A83E-4B1AF0FE44F2}" dt="2025-07-13T05:50:58.384" v="145" actId="1036"/>
          <ac:picMkLst>
            <pc:docMk/>
            <pc:sldMk cId="2669033645" sldId="267"/>
            <ac:picMk id="4" creationId="{ABC341CC-0FF4-6DCF-BE4E-DEF39B158CD0}"/>
          </ac:picMkLst>
        </pc:picChg>
        <pc:cxnChg chg="mod">
          <ac:chgData name="Caiming Xu" userId="e18c41139f0e09dd" providerId="LiveId" clId="{DBD556D2-A6D4-4846-A83E-4B1AF0FE44F2}" dt="2025-07-13T05:49:46.798" v="90" actId="1036"/>
          <ac:cxnSpMkLst>
            <pc:docMk/>
            <pc:sldMk cId="2669033645" sldId="267"/>
            <ac:cxnSpMk id="6" creationId="{46CCDCED-7549-DEC3-1D0A-CD329B58B808}"/>
          </ac:cxnSpMkLst>
        </pc:cxnChg>
        <pc:cxnChg chg="mod">
          <ac:chgData name="Caiming Xu" userId="e18c41139f0e09dd" providerId="LiveId" clId="{DBD556D2-A6D4-4846-A83E-4B1AF0FE44F2}" dt="2025-07-24T19:40:53.818" v="423" actId="1076"/>
          <ac:cxnSpMkLst>
            <pc:docMk/>
            <pc:sldMk cId="2669033645" sldId="267"/>
            <ac:cxnSpMk id="14" creationId="{72C7C2EB-C73C-C48D-2571-64519B5E31F8}"/>
          </ac:cxnSpMkLst>
        </pc:cxnChg>
        <pc:cxnChg chg="mod">
          <ac:chgData name="Caiming Xu" userId="e18c41139f0e09dd" providerId="LiveId" clId="{DBD556D2-A6D4-4846-A83E-4B1AF0FE44F2}" dt="2025-07-24T19:40:53.818" v="423" actId="1076"/>
          <ac:cxnSpMkLst>
            <pc:docMk/>
            <pc:sldMk cId="2669033645" sldId="267"/>
            <ac:cxnSpMk id="15" creationId="{425E9BD0-689B-BEB0-2328-8E8699BABD74}"/>
          </ac:cxnSpMkLst>
        </pc:cxnChg>
        <pc:cxnChg chg="mod">
          <ac:chgData name="Caiming Xu" userId="e18c41139f0e09dd" providerId="LiveId" clId="{DBD556D2-A6D4-4846-A83E-4B1AF0FE44F2}" dt="2025-07-13T05:49:53.997" v="105" actId="1035"/>
          <ac:cxnSpMkLst>
            <pc:docMk/>
            <pc:sldMk cId="2669033645" sldId="267"/>
            <ac:cxnSpMk id="36" creationId="{41476E40-0847-6065-A5D6-A78E5C5E2C52}"/>
          </ac:cxnSpMkLst>
        </pc:cxnChg>
      </pc:sldChg>
      <pc:sldChg chg="addSp delSp modSp add mod ord">
        <pc:chgData name="Caiming Xu" userId="e18c41139f0e09dd" providerId="LiveId" clId="{DBD556D2-A6D4-4846-A83E-4B1AF0FE44F2}" dt="2025-07-26T23:38:22.823" v="434" actId="20578"/>
        <pc:sldMkLst>
          <pc:docMk/>
          <pc:sldMk cId="1153778402" sldId="268"/>
        </pc:sldMkLst>
        <pc:spChg chg="mod">
          <ac:chgData name="Caiming Xu" userId="e18c41139f0e09dd" providerId="LiveId" clId="{DBD556D2-A6D4-4846-A83E-4B1AF0FE44F2}" dt="2025-07-24T19:41:12.529" v="426" actId="1076"/>
          <ac:spMkLst>
            <pc:docMk/>
            <pc:sldMk cId="1153778402" sldId="268"/>
            <ac:spMk id="7" creationId="{7CBF6165-FE46-7C2B-1F61-E4E5911FDC29}"/>
          </ac:spMkLst>
        </pc:spChg>
        <pc:spChg chg="mod">
          <ac:chgData name="Caiming Xu" userId="e18c41139f0e09dd" providerId="LiveId" clId="{DBD556D2-A6D4-4846-A83E-4B1AF0FE44F2}" dt="2025-07-24T19:41:12.529" v="426" actId="1076"/>
          <ac:spMkLst>
            <pc:docMk/>
            <pc:sldMk cId="1153778402" sldId="268"/>
            <ac:spMk id="8" creationId="{8F7753E1-76E3-7FD3-C882-83F2253A4D3D}"/>
          </ac:spMkLst>
        </pc:spChg>
        <pc:spChg chg="mod">
          <ac:chgData name="Caiming Xu" userId="e18c41139f0e09dd" providerId="LiveId" clId="{DBD556D2-A6D4-4846-A83E-4B1AF0FE44F2}" dt="2025-07-13T06:04:12.094" v="326" actId="1038"/>
          <ac:spMkLst>
            <pc:docMk/>
            <pc:sldMk cId="1153778402" sldId="268"/>
            <ac:spMk id="9" creationId="{EF9416A7-CC2D-7E2A-5790-12DDA21A1758}"/>
          </ac:spMkLst>
        </pc:spChg>
        <pc:spChg chg="mod">
          <ac:chgData name="Caiming Xu" userId="e18c41139f0e09dd" providerId="LiveId" clId="{DBD556D2-A6D4-4846-A83E-4B1AF0FE44F2}" dt="2025-07-24T19:41:12.529" v="426" actId="1076"/>
          <ac:spMkLst>
            <pc:docMk/>
            <pc:sldMk cId="1153778402" sldId="268"/>
            <ac:spMk id="12" creationId="{F48D3992-A41C-78D0-3F5C-C7C4AC154074}"/>
          </ac:spMkLst>
        </pc:spChg>
        <pc:spChg chg="mod">
          <ac:chgData name="Caiming Xu" userId="e18c41139f0e09dd" providerId="LiveId" clId="{DBD556D2-A6D4-4846-A83E-4B1AF0FE44F2}" dt="2025-07-24T19:41:22.132" v="433" actId="20577"/>
          <ac:spMkLst>
            <pc:docMk/>
            <pc:sldMk cId="1153778402" sldId="268"/>
            <ac:spMk id="13" creationId="{69D11E7E-0837-5DEC-39DC-82CA6FD31E29}"/>
          </ac:spMkLst>
        </pc:spChg>
        <pc:spChg chg="mod">
          <ac:chgData name="Caiming Xu" userId="e18c41139f0e09dd" providerId="LiveId" clId="{DBD556D2-A6D4-4846-A83E-4B1AF0FE44F2}" dt="2025-07-24T19:41:12.529" v="426" actId="1076"/>
          <ac:spMkLst>
            <pc:docMk/>
            <pc:sldMk cId="1153778402" sldId="268"/>
            <ac:spMk id="16" creationId="{4C9C5BFD-2238-634E-864A-2FA8CE0D92A2}"/>
          </ac:spMkLst>
        </pc:spChg>
        <pc:spChg chg="mod">
          <ac:chgData name="Caiming Xu" userId="e18c41139f0e09dd" providerId="LiveId" clId="{DBD556D2-A6D4-4846-A83E-4B1AF0FE44F2}" dt="2025-07-24T19:41:12.529" v="426" actId="1076"/>
          <ac:spMkLst>
            <pc:docMk/>
            <pc:sldMk cId="1153778402" sldId="268"/>
            <ac:spMk id="19" creationId="{508F766B-EFEE-7670-A086-D934F26BE31A}"/>
          </ac:spMkLst>
        </pc:spChg>
        <pc:spChg chg="mod">
          <ac:chgData name="Caiming Xu" userId="e18c41139f0e09dd" providerId="LiveId" clId="{DBD556D2-A6D4-4846-A83E-4B1AF0FE44F2}" dt="2025-07-24T07:04:15.730" v="338" actId="20577"/>
          <ac:spMkLst>
            <pc:docMk/>
            <pc:sldMk cId="1153778402" sldId="268"/>
            <ac:spMk id="20" creationId="{61715A52-C1ED-C04F-7A3F-B85AF88F6ED0}"/>
          </ac:spMkLst>
        </pc:spChg>
        <pc:spChg chg="mod">
          <ac:chgData name="Caiming Xu" userId="e18c41139f0e09dd" providerId="LiveId" clId="{DBD556D2-A6D4-4846-A83E-4B1AF0FE44F2}" dt="2025-07-24T19:41:12.529" v="426" actId="1076"/>
          <ac:spMkLst>
            <pc:docMk/>
            <pc:sldMk cId="1153778402" sldId="268"/>
            <ac:spMk id="37" creationId="{6AFBDD7A-67CC-8F7B-4DD4-4E303C00BB1A}"/>
          </ac:spMkLst>
        </pc:spChg>
        <pc:grpChg chg="mod">
          <ac:chgData name="Caiming Xu" userId="e18c41139f0e09dd" providerId="LiveId" clId="{DBD556D2-A6D4-4846-A83E-4B1AF0FE44F2}" dt="2025-07-24T19:41:12.529" v="426" actId="1076"/>
          <ac:grpSpMkLst>
            <pc:docMk/>
            <pc:sldMk cId="1153778402" sldId="268"/>
            <ac:grpSpMk id="21" creationId="{4825A96F-ADE8-CF0B-9C61-4FDB23499877}"/>
          </ac:grpSpMkLst>
        </pc:grpChg>
        <pc:grpChg chg="mod">
          <ac:chgData name="Caiming Xu" userId="e18c41139f0e09dd" providerId="LiveId" clId="{DBD556D2-A6D4-4846-A83E-4B1AF0FE44F2}" dt="2025-07-13T06:04:18.841" v="333" actId="1036"/>
          <ac:grpSpMkLst>
            <pc:docMk/>
            <pc:sldMk cId="1153778402" sldId="268"/>
            <ac:grpSpMk id="27" creationId="{F25C93BC-FE4A-52F0-46D1-0A4BC67F7AC6}"/>
          </ac:grpSpMkLst>
        </pc:grpChg>
        <pc:picChg chg="add del mod modCrop">
          <ac:chgData name="Caiming Xu" userId="e18c41139f0e09dd" providerId="LiveId" clId="{DBD556D2-A6D4-4846-A83E-4B1AF0FE44F2}" dt="2025-07-24T19:32:31.508" v="372" actId="478"/>
          <ac:picMkLst>
            <pc:docMk/>
            <pc:sldMk cId="1153778402" sldId="268"/>
            <ac:picMk id="11" creationId="{5F30D159-61B7-4970-6A05-A6E428B95C35}"/>
          </ac:picMkLst>
        </pc:picChg>
        <pc:picChg chg="add mod modCrop">
          <ac:chgData name="Caiming Xu" userId="e18c41139f0e09dd" providerId="LiveId" clId="{DBD556D2-A6D4-4846-A83E-4B1AF0FE44F2}" dt="2025-07-24T19:41:12.529" v="426" actId="1076"/>
          <ac:picMkLst>
            <pc:docMk/>
            <pc:sldMk cId="1153778402" sldId="268"/>
            <ac:picMk id="26" creationId="{989CAB69-3334-4E77-A411-ED95E3B87BEC}"/>
          </ac:picMkLst>
        </pc:picChg>
        <pc:cxnChg chg="mod">
          <ac:chgData name="Caiming Xu" userId="e18c41139f0e09dd" providerId="LiveId" clId="{DBD556D2-A6D4-4846-A83E-4B1AF0FE44F2}" dt="2025-07-24T19:40:29.778" v="419" actId="1038"/>
          <ac:cxnSpMkLst>
            <pc:docMk/>
            <pc:sldMk cId="1153778402" sldId="268"/>
            <ac:cxnSpMk id="6" creationId="{EF33D278-B552-5FB7-9820-D5AB86B5FD91}"/>
          </ac:cxnSpMkLst>
        </pc:cxnChg>
        <pc:cxnChg chg="mod">
          <ac:chgData name="Caiming Xu" userId="e18c41139f0e09dd" providerId="LiveId" clId="{DBD556D2-A6D4-4846-A83E-4B1AF0FE44F2}" dt="2025-07-24T19:40:29.778" v="419" actId="1038"/>
          <ac:cxnSpMkLst>
            <pc:docMk/>
            <pc:sldMk cId="1153778402" sldId="268"/>
            <ac:cxnSpMk id="14" creationId="{6B2D7D55-A3B0-E9D2-CA7F-836DCCD0D35B}"/>
          </ac:cxnSpMkLst>
        </pc:cxnChg>
        <pc:cxnChg chg="mod">
          <ac:chgData name="Caiming Xu" userId="e18c41139f0e09dd" providerId="LiveId" clId="{DBD556D2-A6D4-4846-A83E-4B1AF0FE44F2}" dt="2025-07-24T19:41:12.529" v="426" actId="1076"/>
          <ac:cxnSpMkLst>
            <pc:docMk/>
            <pc:sldMk cId="1153778402" sldId="268"/>
            <ac:cxnSpMk id="15" creationId="{2D7649A8-87E5-D0A8-F5B0-3024F9B8782F}"/>
          </ac:cxnSpMkLst>
        </pc:cxnChg>
        <pc:cxnChg chg="mod">
          <ac:chgData name="Caiming Xu" userId="e18c41139f0e09dd" providerId="LiveId" clId="{DBD556D2-A6D4-4846-A83E-4B1AF0FE44F2}" dt="2025-07-24T19:41:12.529" v="426" actId="1076"/>
          <ac:cxnSpMkLst>
            <pc:docMk/>
            <pc:sldMk cId="1153778402" sldId="268"/>
            <ac:cxnSpMk id="36" creationId="{312507CE-975F-BE9E-AD18-DAC08F307CEC}"/>
          </ac:cxnSpMkLst>
        </pc:cxnChg>
      </pc:sldChg>
    </pc:docChg>
  </pc:docChgLst>
  <pc:docChgLst>
    <pc:chgData name="Caiming Xu" userId="e18c41139f0e09dd" providerId="LiveId" clId="{ADD0C101-94BF-2E4B-9DBD-F95E197B4567}"/>
    <pc:docChg chg="undo redo custSel addSld modSld">
      <pc:chgData name="Caiming Xu" userId="e18c41139f0e09dd" providerId="LiveId" clId="{ADD0C101-94BF-2E4B-9DBD-F95E197B4567}" dt="2025-06-10T07:17:27.841" v="1386"/>
      <pc:docMkLst>
        <pc:docMk/>
      </pc:docMkLst>
      <pc:sldChg chg="addSp modSp mod">
        <pc:chgData name="Caiming Xu" userId="e18c41139f0e09dd" providerId="LiveId" clId="{ADD0C101-94BF-2E4B-9DBD-F95E197B4567}" dt="2025-05-22T06:12:49.138" v="967" actId="164"/>
        <pc:sldMkLst>
          <pc:docMk/>
          <pc:sldMk cId="2132240086" sldId="256"/>
        </pc:sldMkLst>
      </pc:sldChg>
      <pc:sldChg chg="addSp delSp modSp mod">
        <pc:chgData name="Caiming Xu" userId="e18c41139f0e09dd" providerId="LiveId" clId="{ADD0C101-94BF-2E4B-9DBD-F95E197B4567}" dt="2025-05-22T06:12:50.438" v="968"/>
        <pc:sldMkLst>
          <pc:docMk/>
          <pc:sldMk cId="1450741610" sldId="257"/>
        </pc:sldMkLst>
      </pc:sldChg>
      <pc:sldChg chg="addSp delSp modSp mod">
        <pc:chgData name="Caiming Xu" userId="e18c41139f0e09dd" providerId="LiveId" clId="{ADD0C101-94BF-2E4B-9DBD-F95E197B4567}" dt="2025-06-10T07:17:27.841" v="1386"/>
        <pc:sldMkLst>
          <pc:docMk/>
          <pc:sldMk cId="3527795092" sldId="258"/>
        </pc:sldMkLst>
      </pc:sldChg>
      <pc:sldChg chg="addSp modSp mod">
        <pc:chgData name="Caiming Xu" userId="e18c41139f0e09dd" providerId="LiveId" clId="{ADD0C101-94BF-2E4B-9DBD-F95E197B4567}" dt="2025-05-22T06:18:22.521" v="982"/>
        <pc:sldMkLst>
          <pc:docMk/>
          <pc:sldMk cId="841826548" sldId="259"/>
        </pc:sldMkLst>
      </pc:sldChg>
      <pc:sldChg chg="addSp modSp mod">
        <pc:chgData name="Caiming Xu" userId="e18c41139f0e09dd" providerId="LiveId" clId="{ADD0C101-94BF-2E4B-9DBD-F95E197B4567}" dt="2025-05-22T06:22:22.198" v="1023" actId="1076"/>
        <pc:sldMkLst>
          <pc:docMk/>
          <pc:sldMk cId="3928639220" sldId="260"/>
        </pc:sldMkLst>
      </pc:sldChg>
      <pc:sldChg chg="addSp delSp modSp mod">
        <pc:chgData name="Caiming Xu" userId="e18c41139f0e09dd" providerId="LiveId" clId="{ADD0C101-94BF-2E4B-9DBD-F95E197B4567}" dt="2025-05-22T06:23:19.611" v="1041"/>
        <pc:sldMkLst>
          <pc:docMk/>
          <pc:sldMk cId="89749538" sldId="261"/>
        </pc:sldMkLst>
      </pc:sldChg>
      <pc:sldChg chg="addSp delSp modSp add mod">
        <pc:chgData name="Caiming Xu" userId="e18c41139f0e09dd" providerId="LiveId" clId="{ADD0C101-94BF-2E4B-9DBD-F95E197B4567}" dt="2025-05-22T06:20:24.801" v="1005"/>
        <pc:sldMkLst>
          <pc:docMk/>
          <pc:sldMk cId="2035111799" sldId="262"/>
        </pc:sldMkLst>
      </pc:sldChg>
      <pc:sldChg chg="addSp delSp modSp add mod">
        <pc:chgData name="Caiming Xu" userId="e18c41139f0e09dd" providerId="LiveId" clId="{ADD0C101-94BF-2E4B-9DBD-F95E197B4567}" dt="2025-05-22T06:21:01.182" v="1017"/>
        <pc:sldMkLst>
          <pc:docMk/>
          <pc:sldMk cId="435785349" sldId="263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C68232-83C2-6A90-F28D-263F3F1170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EDCEE58-776E-6EA7-8D5B-F4C10349D1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B7454F-DAB8-F5F1-38B8-575B478EC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FF5B87-4602-DCAF-91B1-DBBC151B8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69AD5D4-1225-4C95-F11B-7EA0696AB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75235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2F37FC-1B05-0A3B-4A5B-556EACBDFC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55E39A7-A978-9E9B-86ED-DF170F7CCA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1812C4-036C-5B55-6CA6-8B91F03032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C7DED9-BA19-CB58-E90A-D0F3C96181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3A1F3C9-13E4-86C9-F9CE-BFFBD1EDD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77330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EA3CB9F-26ED-185D-9FC4-47F800A899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397D726-26D1-E4E3-A96C-96D998A766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6258D3-D5E3-BFAC-29D1-102288DA3E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A3AF99-27A1-F44D-BFC8-2C58EA41B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171012-2EB7-0FA9-B1C4-609CF4542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04250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02A197-8AEA-DBF8-B8D3-C58F84657F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FFD142-9E0A-64E7-743B-68BFF8F81B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AD1A46-034D-3276-E162-0A5A2EACB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E8C3FB-4DC8-DFF6-D3D6-5BE4126774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52C391-E100-728F-D914-02D5B648D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0993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073D65-E0AB-0644-8782-86A5727BF8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E9044EF-802D-6486-D002-3A9829ACBC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930DFC7-3D4B-603B-CF05-6700E6ADF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386B0C-A7A2-89A0-50A8-D86516C41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8F23E9-0F34-DCAF-276C-EF1D8DDD07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66113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A1A728-C6FB-AE88-7CBC-BEBC61C3F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20FEF51-E96A-62E7-06D1-A73A3DBE4E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561850B-D6C2-26E7-E45A-B817651BFB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7CCD202-3EDB-91AA-311E-E23E1F9F3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FCA7F3A-BB39-58A1-A8EC-F85B9025F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FA82F92-BA76-CCDF-EF94-164F620633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80545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A4EFAD-316E-42DB-4E91-618124B80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687FE9A-FBDF-2194-8C8F-8CC63A59F5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92CEF31-9431-36DE-E4D4-BE9AE05B05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3C7E0E3-E64D-B9AE-3BE5-F325744320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B7FAC2E-B68C-0639-CA52-36AC1B27026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227F203-EB19-3C11-FE64-407AAD4D3E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3962174-442B-7CC3-3C91-68EEE7AB76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0EBE96C-9C08-A167-CB99-BF9D352CC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097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D9E195-E782-F8ED-5073-A45C5D74B2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CBEBB03-ADAC-2D08-065B-342FD28EA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564C72B-CC67-8753-0662-56B49684A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F445EEE-C1B8-7BAD-A705-654D0A254F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48377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D47C9AE-DD30-758C-E12F-A3BA25044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4150EEC-7C56-1888-9C3F-28E6B4AA3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EC5FE3B-73DA-E670-35E9-76FD62647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085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681365-15FE-63B3-A504-1D70D2D6B7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8D73BB2-EAE0-D484-6340-902FB2104A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5974D1F-5FA3-7016-9719-8CD6546AA3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EB66D8C-45F9-5410-86C9-0819B3DEE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1DE7AD-0F77-412C-7806-3170552207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24F444F-F95D-8041-CCD1-6D7BD3F13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182688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30264F-8457-7E4B-A11D-C0F70D4CB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02E023F-B305-716A-9B04-9BC33248FA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4CD1FBD-0CA0-3ACC-805A-A34717CE3A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BA209C1-2C8E-6049-1687-339DE7305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F362495-BE3C-D628-59CB-DFBA0042D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4149B1-5519-45AC-5970-9B05632C05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236841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6E84DAD-8D81-2C83-F251-CF423C9051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690C10C-DCB2-9DEA-9BE6-F895FCB5D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CBAECE-FFA1-1F0F-50C8-6C4B79EF92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7BA563-42B2-8A45-A8BC-CC5674E84F16}" type="datetimeFigureOut">
              <a:rPr kumimoji="1" lang="zh-CN" altLang="en-US" smtClean="0"/>
              <a:t>2025/7/2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8781EB-D72A-02D6-E426-B70281D93E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B176A1-C306-6C8A-82A0-5D5904E0A7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5DBC36-27B4-084B-8DB4-E3A8DD4834C5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19091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7FDE354-B647-EA89-393F-BE4659FDFB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458485" y="2226678"/>
            <a:ext cx="3261570" cy="175323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4939D3E-90EF-76E0-D450-AA5186E32A6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046236" y="2250015"/>
            <a:ext cx="3261570" cy="1784040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0D3724C5-278F-0B46-92EF-B4727542F29F}"/>
              </a:ext>
            </a:extLst>
          </p:cNvPr>
          <p:cNvGrpSpPr>
            <a:grpSpLocks noChangeAspect="1"/>
          </p:cNvGrpSpPr>
          <p:nvPr/>
        </p:nvGrpSpPr>
        <p:grpSpPr>
          <a:xfrm>
            <a:off x="6608402" y="1753319"/>
            <a:ext cx="4983437" cy="1430977"/>
            <a:chOff x="7935928" y="3008119"/>
            <a:chExt cx="2743420" cy="787763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5A0704D2-6906-49DE-364D-7BDBD420E93B}"/>
                </a:ext>
              </a:extLst>
            </p:cNvPr>
            <p:cNvSpPr txBox="1"/>
            <p:nvPr/>
          </p:nvSpPr>
          <p:spPr>
            <a:xfrm>
              <a:off x="7935928" y="3562422"/>
              <a:ext cx="440520" cy="2027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463A877-3C6F-4374-3D8E-C25A43384A3F}"/>
                </a:ext>
              </a:extLst>
            </p:cNvPr>
            <p:cNvSpPr txBox="1"/>
            <p:nvPr/>
          </p:nvSpPr>
          <p:spPr>
            <a:xfrm>
              <a:off x="10208818" y="3575618"/>
              <a:ext cx="470530" cy="220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6DA03D16-0D26-1B0F-F235-EEA6CFC35E33}"/>
                </a:ext>
              </a:extLst>
            </p:cNvPr>
            <p:cNvGrpSpPr/>
            <p:nvPr/>
          </p:nvGrpSpPr>
          <p:grpSpPr>
            <a:xfrm>
              <a:off x="8789749" y="3008119"/>
              <a:ext cx="1056184" cy="220267"/>
              <a:chOff x="3919713" y="3233578"/>
              <a:chExt cx="1056184" cy="220267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A901A56F-1A4D-71A7-DBBE-90C754ACDE19}"/>
                  </a:ext>
                </a:extLst>
              </p:cNvPr>
              <p:cNvSpPr txBox="1"/>
              <p:nvPr/>
            </p:nvSpPr>
            <p:spPr>
              <a:xfrm>
                <a:off x="3919713" y="3233578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6021E058-0C63-8E9B-4CE7-1223CD3EBC88}"/>
                  </a:ext>
                </a:extLst>
              </p:cNvPr>
              <p:cNvSpPr txBox="1"/>
              <p:nvPr/>
            </p:nvSpPr>
            <p:spPr>
              <a:xfrm>
                <a:off x="4226614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4219856A-D131-FDC9-371B-DEEAEDC45E35}"/>
                  </a:ext>
                </a:extLst>
              </p:cNvPr>
              <p:cNvSpPr txBox="1"/>
              <p:nvPr/>
            </p:nvSpPr>
            <p:spPr>
              <a:xfrm>
                <a:off x="4507484" y="3233581"/>
                <a:ext cx="180200" cy="220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C6209E8C-C94E-3A84-6DB7-9C892420CCD7}"/>
                  </a:ext>
                </a:extLst>
              </p:cNvPr>
              <p:cNvSpPr txBox="1"/>
              <p:nvPr/>
            </p:nvSpPr>
            <p:spPr>
              <a:xfrm>
                <a:off x="4795697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DBDA3BC3-CD1C-7274-05AA-C99B0DD16566}"/>
              </a:ext>
            </a:extLst>
          </p:cNvPr>
          <p:cNvGrpSpPr>
            <a:grpSpLocks noChangeAspect="1"/>
          </p:cNvGrpSpPr>
          <p:nvPr/>
        </p:nvGrpSpPr>
        <p:grpSpPr>
          <a:xfrm>
            <a:off x="627161" y="1746580"/>
            <a:ext cx="5641381" cy="2025288"/>
            <a:chOff x="2785671" y="2954097"/>
            <a:chExt cx="2714625" cy="1057595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61DFD30-ED25-8967-33C7-E34ACFBF846E}"/>
                </a:ext>
              </a:extLst>
            </p:cNvPr>
            <p:cNvSpPr txBox="1"/>
            <p:nvPr/>
          </p:nvSpPr>
          <p:spPr>
            <a:xfrm>
              <a:off x="2785671" y="3481934"/>
              <a:ext cx="453927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0BEA0B48-CDC9-2EFD-07B1-39E0462503D0}"/>
                </a:ext>
              </a:extLst>
            </p:cNvPr>
            <p:cNvSpPr txBox="1"/>
            <p:nvPr/>
          </p:nvSpPr>
          <p:spPr>
            <a:xfrm>
              <a:off x="3213558" y="3828616"/>
              <a:ext cx="215056" cy="18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线连接符 13">
              <a:extLst>
                <a:ext uri="{FF2B5EF4-FFF2-40B4-BE49-F238E27FC236}">
                  <a16:creationId xmlns:a16="http://schemas.microsoft.com/office/drawing/2014/main" id="{4D500BFD-26C1-13C8-28CF-CDCC68C79F24}"/>
                </a:ext>
              </a:extLst>
            </p:cNvPr>
            <p:cNvCxnSpPr>
              <a:cxnSpLocks/>
            </p:cNvCxnSpPr>
            <p:nvPr/>
          </p:nvCxnSpPr>
          <p:spPr>
            <a:xfrm>
              <a:off x="3414528" y="3926538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线连接符 14">
              <a:extLst>
                <a:ext uri="{FF2B5EF4-FFF2-40B4-BE49-F238E27FC236}">
                  <a16:creationId xmlns:a16="http://schemas.microsoft.com/office/drawing/2014/main" id="{55C6DBD4-5EDB-8755-7797-229B9045F37F}"/>
                </a:ext>
              </a:extLst>
            </p:cNvPr>
            <p:cNvCxnSpPr>
              <a:cxnSpLocks/>
            </p:cNvCxnSpPr>
            <p:nvPr/>
          </p:nvCxnSpPr>
          <p:spPr>
            <a:xfrm>
              <a:off x="3414528" y="3587388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980BAC4B-4EA8-CA5D-FE28-5D48DBE73DAB}"/>
                </a:ext>
              </a:extLst>
            </p:cNvPr>
            <p:cNvSpPr txBox="1"/>
            <p:nvPr/>
          </p:nvSpPr>
          <p:spPr>
            <a:xfrm>
              <a:off x="3213558" y="3487304"/>
              <a:ext cx="215056" cy="18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82C7E0BE-0499-B8B2-C350-7C1538806105}"/>
                </a:ext>
              </a:extLst>
            </p:cNvPr>
            <p:cNvSpPr txBox="1"/>
            <p:nvPr/>
          </p:nvSpPr>
          <p:spPr>
            <a:xfrm>
              <a:off x="5053905" y="3481934"/>
              <a:ext cx="446391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56B14B4D-9EA8-1801-9F04-73035682F55C}"/>
                </a:ext>
              </a:extLst>
            </p:cNvPr>
            <p:cNvGrpSpPr/>
            <p:nvPr/>
          </p:nvGrpSpPr>
          <p:grpSpPr>
            <a:xfrm>
              <a:off x="3803906" y="2954097"/>
              <a:ext cx="1033486" cy="226766"/>
              <a:chOff x="3965831" y="3305229"/>
              <a:chExt cx="1033486" cy="226766"/>
            </a:xfrm>
          </p:grpSpPr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D638EF77-7055-71DF-F03F-0C1F4E3F84A4}"/>
                  </a:ext>
                </a:extLst>
              </p:cNvPr>
              <p:cNvSpPr txBox="1"/>
              <p:nvPr/>
            </p:nvSpPr>
            <p:spPr>
              <a:xfrm>
                <a:off x="3965831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9555B4E8-5C4D-739A-8B43-4DFBCD3985B4}"/>
                  </a:ext>
                </a:extLst>
              </p:cNvPr>
              <p:cNvSpPr txBox="1"/>
              <p:nvPr/>
            </p:nvSpPr>
            <p:spPr>
              <a:xfrm>
                <a:off x="4272728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BF9B9C9F-4A35-4592-B459-3B0066983B6B}"/>
                  </a:ext>
                </a:extLst>
              </p:cNvPr>
              <p:cNvSpPr txBox="1"/>
              <p:nvPr/>
            </p:nvSpPr>
            <p:spPr>
              <a:xfrm>
                <a:off x="4553599" y="3305229"/>
                <a:ext cx="157513" cy="2089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3C4F48F5-D522-D931-BB49-81052E46CD42}"/>
                  </a:ext>
                </a:extLst>
              </p:cNvPr>
              <p:cNvSpPr txBox="1"/>
              <p:nvPr/>
            </p:nvSpPr>
            <p:spPr>
              <a:xfrm>
                <a:off x="4841804" y="3305229"/>
                <a:ext cx="157513" cy="2089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" name="直线连接符 5">
              <a:extLst>
                <a:ext uri="{FF2B5EF4-FFF2-40B4-BE49-F238E27FC236}">
                  <a16:creationId xmlns:a16="http://schemas.microsoft.com/office/drawing/2014/main" id="{ED06550C-E6ED-6ED6-6D5D-FDE307420916}"/>
                </a:ext>
              </a:extLst>
            </p:cNvPr>
            <p:cNvCxnSpPr>
              <a:cxnSpLocks/>
            </p:cNvCxnSpPr>
            <p:nvPr/>
          </p:nvCxnSpPr>
          <p:spPr>
            <a:xfrm>
              <a:off x="3414528" y="3354429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83459769-DAEA-DFB0-7F30-5A84222B8032}"/>
                </a:ext>
              </a:extLst>
            </p:cNvPr>
            <p:cNvSpPr txBox="1"/>
            <p:nvPr/>
          </p:nvSpPr>
          <p:spPr>
            <a:xfrm>
              <a:off x="3213558" y="3255184"/>
              <a:ext cx="215056" cy="183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F780D73F-030C-178C-78CD-5FD187C6C9D4}"/>
              </a:ext>
            </a:extLst>
          </p:cNvPr>
          <p:cNvSpPr txBox="1"/>
          <p:nvPr/>
        </p:nvSpPr>
        <p:spPr>
          <a:xfrm>
            <a:off x="5619967" y="819805"/>
            <a:ext cx="12971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8EC93FEB-EC36-4F13-D766-65449F60D7E0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BF27719F-DEB8-BDB0-FFF0-186B7F2DA28A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96B3D5AA-8099-3373-F009-A7C9605B0510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F97EAAE0-87F1-470A-B80F-BBE947E1DF72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57AA87DD-0196-D631-70A7-E140AE9E84EC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7BFB4511-DCD6-5D3A-C942-61A51023BE20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1B935418-0435-D53B-1CA8-451F8C68275D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929242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F145735-04E3-85E8-B3C5-05ACF39F20D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 descr="手机屏幕的截图&#10;&#10;AI 生成的内容可能不正确。">
            <a:extLst>
              <a:ext uri="{FF2B5EF4-FFF2-40B4-BE49-F238E27FC236}">
                <a16:creationId xmlns:a16="http://schemas.microsoft.com/office/drawing/2014/main" id="{FDB3C25B-A521-6A2F-66D3-102DD767AE59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677156" y="2264834"/>
            <a:ext cx="2679443" cy="1282311"/>
          </a:xfrm>
          <a:prstGeom prst="rect">
            <a:avLst/>
          </a:prstGeom>
        </p:spPr>
      </p:pic>
      <p:pic>
        <p:nvPicPr>
          <p:cNvPr id="3" name="图片 2" descr="图片包含 室内, 桌子, 盒子, 监控&#10;&#10;AI 生成的内容可能不正确。">
            <a:extLst>
              <a:ext uri="{FF2B5EF4-FFF2-40B4-BE49-F238E27FC236}">
                <a16:creationId xmlns:a16="http://schemas.microsoft.com/office/drawing/2014/main" id="{687B836F-82D0-1E12-1F3D-7CA78CDBA4B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166010" y="2252843"/>
            <a:ext cx="3100454" cy="1436494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B2351148-4CBB-5BCB-E426-D8E031DC71CF}"/>
              </a:ext>
            </a:extLst>
          </p:cNvPr>
          <p:cNvGrpSpPr>
            <a:grpSpLocks noChangeAspect="1"/>
          </p:cNvGrpSpPr>
          <p:nvPr/>
        </p:nvGrpSpPr>
        <p:grpSpPr>
          <a:xfrm>
            <a:off x="6783923" y="1829509"/>
            <a:ext cx="4479526" cy="1274559"/>
            <a:chOff x="8032557" y="3008119"/>
            <a:chExt cx="2466014" cy="701655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FDDFACF0-A655-8674-BF28-EA3E1748EFEB}"/>
                </a:ext>
              </a:extLst>
            </p:cNvPr>
            <p:cNvSpPr txBox="1"/>
            <p:nvPr/>
          </p:nvSpPr>
          <p:spPr>
            <a:xfrm>
              <a:off x="8032557" y="3476317"/>
              <a:ext cx="543776" cy="220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B9F5D4AE-4049-DC42-9DF3-03FC4B9C4744}"/>
                </a:ext>
              </a:extLst>
            </p:cNvPr>
            <p:cNvSpPr txBox="1"/>
            <p:nvPr/>
          </p:nvSpPr>
          <p:spPr>
            <a:xfrm>
              <a:off x="10028040" y="3489510"/>
              <a:ext cx="470531" cy="220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8193EA95-7522-1EAE-B6C4-45390ADC628D}"/>
                </a:ext>
              </a:extLst>
            </p:cNvPr>
            <p:cNvGrpSpPr/>
            <p:nvPr/>
          </p:nvGrpSpPr>
          <p:grpSpPr>
            <a:xfrm>
              <a:off x="8789749" y="3008119"/>
              <a:ext cx="1056184" cy="220267"/>
              <a:chOff x="3919713" y="3233578"/>
              <a:chExt cx="1056184" cy="220267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D7D4C61B-568A-8322-D4CE-CCA882F771B6}"/>
                  </a:ext>
                </a:extLst>
              </p:cNvPr>
              <p:cNvSpPr txBox="1"/>
              <p:nvPr/>
            </p:nvSpPr>
            <p:spPr>
              <a:xfrm>
                <a:off x="3919713" y="3233578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4AD49E53-2B88-D3E4-40DB-3C7069BFCCDC}"/>
                  </a:ext>
                </a:extLst>
              </p:cNvPr>
              <p:cNvSpPr txBox="1"/>
              <p:nvPr/>
            </p:nvSpPr>
            <p:spPr>
              <a:xfrm>
                <a:off x="4226614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273BC57B-178C-433B-F4BA-FB987EED3CE5}"/>
                  </a:ext>
                </a:extLst>
              </p:cNvPr>
              <p:cNvSpPr txBox="1"/>
              <p:nvPr/>
            </p:nvSpPr>
            <p:spPr>
              <a:xfrm>
                <a:off x="4507484" y="3233581"/>
                <a:ext cx="180200" cy="220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0E70A612-7FF9-53A6-BFD8-1251D42121F9}"/>
                  </a:ext>
                </a:extLst>
              </p:cNvPr>
              <p:cNvSpPr txBox="1"/>
              <p:nvPr/>
            </p:nvSpPr>
            <p:spPr>
              <a:xfrm>
                <a:off x="4795697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C392F3A4-8979-82DC-58A9-454EF6007A75}"/>
              </a:ext>
            </a:extLst>
          </p:cNvPr>
          <p:cNvSpPr txBox="1"/>
          <p:nvPr/>
        </p:nvSpPr>
        <p:spPr>
          <a:xfrm>
            <a:off x="655896" y="2757385"/>
            <a:ext cx="987771" cy="400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9EE1156-FFD8-57B4-2A9C-2BF1A7CE50EC}"/>
              </a:ext>
            </a:extLst>
          </p:cNvPr>
          <p:cNvSpPr txBox="1"/>
          <p:nvPr/>
        </p:nvSpPr>
        <p:spPr>
          <a:xfrm>
            <a:off x="1643545" y="3392703"/>
            <a:ext cx="446917" cy="3505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线连接符 13">
            <a:extLst>
              <a:ext uri="{FF2B5EF4-FFF2-40B4-BE49-F238E27FC236}">
                <a16:creationId xmlns:a16="http://schemas.microsoft.com/office/drawing/2014/main" id="{8E6A83BD-99B6-C858-E281-0E99C847D7D4}"/>
              </a:ext>
            </a:extLst>
          </p:cNvPr>
          <p:cNvCxnSpPr>
            <a:cxnSpLocks/>
          </p:cNvCxnSpPr>
          <p:nvPr/>
        </p:nvCxnSpPr>
        <p:spPr>
          <a:xfrm>
            <a:off x="2061189" y="3580223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73562E04-F7C1-0779-ADFE-16EEE41B4570}"/>
              </a:ext>
            </a:extLst>
          </p:cNvPr>
          <p:cNvCxnSpPr>
            <a:cxnSpLocks/>
          </p:cNvCxnSpPr>
          <p:nvPr/>
        </p:nvCxnSpPr>
        <p:spPr>
          <a:xfrm>
            <a:off x="2061189" y="3123639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324A0697-DEB5-3CFE-93F9-39C0BFACF5FE}"/>
              </a:ext>
            </a:extLst>
          </p:cNvPr>
          <p:cNvSpPr txBox="1"/>
          <p:nvPr/>
        </p:nvSpPr>
        <p:spPr>
          <a:xfrm>
            <a:off x="1643545" y="2946267"/>
            <a:ext cx="446917" cy="3505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3F2EA3D-0002-38F4-901F-4F7158DE9C1C}"/>
              </a:ext>
            </a:extLst>
          </p:cNvPr>
          <p:cNvSpPr txBox="1"/>
          <p:nvPr/>
        </p:nvSpPr>
        <p:spPr>
          <a:xfrm>
            <a:off x="5266464" y="2746096"/>
            <a:ext cx="8547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E7738A29-93EC-CE98-75D1-73DA41130166}"/>
              </a:ext>
            </a:extLst>
          </p:cNvPr>
          <p:cNvGrpSpPr/>
          <p:nvPr/>
        </p:nvGrpSpPr>
        <p:grpSpPr>
          <a:xfrm>
            <a:off x="2743195" y="1746580"/>
            <a:ext cx="2147732" cy="434256"/>
            <a:chOff x="3965831" y="3305229"/>
            <a:chExt cx="1033486" cy="226766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E5CE60C6-E6B3-09BA-FD2F-6ECFE05CC6F3}"/>
                </a:ext>
              </a:extLst>
            </p:cNvPr>
            <p:cNvSpPr txBox="1"/>
            <p:nvPr/>
          </p:nvSpPr>
          <p:spPr>
            <a:xfrm>
              <a:off x="3965831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45655D49-7C1D-E6F0-4385-790516E26A9B}"/>
                </a:ext>
              </a:extLst>
            </p:cNvPr>
            <p:cNvSpPr txBox="1"/>
            <p:nvPr/>
          </p:nvSpPr>
          <p:spPr>
            <a:xfrm>
              <a:off x="42727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D2ECACA7-5718-23EA-4A32-3DAF6269CC30}"/>
                </a:ext>
              </a:extLst>
            </p:cNvPr>
            <p:cNvSpPr txBox="1"/>
            <p:nvPr/>
          </p:nvSpPr>
          <p:spPr>
            <a:xfrm>
              <a:off x="4553599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46B8EA16-60E9-E164-5BB0-7050774DF363}"/>
                </a:ext>
              </a:extLst>
            </p:cNvPr>
            <p:cNvSpPr txBox="1"/>
            <p:nvPr/>
          </p:nvSpPr>
          <p:spPr>
            <a:xfrm>
              <a:off x="4841804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" name="直线连接符 5">
            <a:extLst>
              <a:ext uri="{FF2B5EF4-FFF2-40B4-BE49-F238E27FC236}">
                <a16:creationId xmlns:a16="http://schemas.microsoft.com/office/drawing/2014/main" id="{F13C128D-341A-7B7B-C0FE-6F37147D6F19}"/>
              </a:ext>
            </a:extLst>
          </p:cNvPr>
          <p:cNvCxnSpPr>
            <a:cxnSpLocks/>
          </p:cNvCxnSpPr>
          <p:nvPr/>
        </p:nvCxnSpPr>
        <p:spPr>
          <a:xfrm>
            <a:off x="2061189" y="2806111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DAD81296-5CBC-2FE8-0BB6-13F910C6FEBC}"/>
              </a:ext>
            </a:extLst>
          </p:cNvPr>
          <p:cNvSpPr txBox="1"/>
          <p:nvPr/>
        </p:nvSpPr>
        <p:spPr>
          <a:xfrm>
            <a:off x="1643545" y="2637490"/>
            <a:ext cx="446917" cy="3505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4BBF8A8-834E-D0C6-A6E1-D13AFAD0B24F}"/>
              </a:ext>
            </a:extLst>
          </p:cNvPr>
          <p:cNvSpPr txBox="1"/>
          <p:nvPr/>
        </p:nvSpPr>
        <p:spPr>
          <a:xfrm>
            <a:off x="5619967" y="819805"/>
            <a:ext cx="142539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EE29213F-B741-ABC3-6778-FD9590761E6B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4292586D-010F-18F5-AC84-474BB60ECFF4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C2DAC1D4-7171-14C9-2F8D-F9A12A544342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01292E70-13B2-B0ED-61F4-1E58FD214868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11273C56-064D-990A-303A-26FE7E2A6B6E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56D78D86-510F-FC45-B180-2A9B65A2E94A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AA67465E-2BA3-817F-0004-C0EA4F629FBE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35" name="直线连接符 34">
            <a:extLst>
              <a:ext uri="{FF2B5EF4-FFF2-40B4-BE49-F238E27FC236}">
                <a16:creationId xmlns:a16="http://schemas.microsoft.com/office/drawing/2014/main" id="{94C8011A-84FC-6552-5976-FDF7796ADE99}"/>
              </a:ext>
            </a:extLst>
          </p:cNvPr>
          <p:cNvCxnSpPr>
            <a:cxnSpLocks/>
          </p:cNvCxnSpPr>
          <p:nvPr/>
        </p:nvCxnSpPr>
        <p:spPr>
          <a:xfrm>
            <a:off x="2061189" y="2401293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A6F89928-090B-D44A-E0E3-C8851A5713B4}"/>
              </a:ext>
            </a:extLst>
          </p:cNvPr>
          <p:cNvSpPr txBox="1"/>
          <p:nvPr/>
        </p:nvSpPr>
        <p:spPr>
          <a:xfrm>
            <a:off x="1643545" y="2239664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06856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E5A08FB-8DCF-B476-145E-1EBF41E8B8C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>
            <a:extLst>
              <a:ext uri="{FF2B5EF4-FFF2-40B4-BE49-F238E27FC236}">
                <a16:creationId xmlns:a16="http://schemas.microsoft.com/office/drawing/2014/main" id="{1DCB2C0B-217E-E13C-2639-A1EE81344008}"/>
              </a:ext>
            </a:extLst>
          </p:cNvPr>
          <p:cNvGrpSpPr/>
          <p:nvPr/>
        </p:nvGrpSpPr>
        <p:grpSpPr>
          <a:xfrm>
            <a:off x="571050" y="2002559"/>
            <a:ext cx="5651950" cy="1813679"/>
            <a:chOff x="830103" y="1746580"/>
            <a:chExt cx="5651950" cy="1813679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4BB0406B-33DC-2E97-1E4B-9161165CA38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2181536" y="2161946"/>
              <a:ext cx="3372852" cy="1263397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94CEC37D-21E0-1F93-42A0-1DC66B207EC4}"/>
                </a:ext>
              </a:extLst>
            </p:cNvPr>
            <p:cNvSpPr txBox="1"/>
            <p:nvPr/>
          </p:nvSpPr>
          <p:spPr>
            <a:xfrm>
              <a:off x="830103" y="2607087"/>
              <a:ext cx="943326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GAS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5093B62-4292-7DE5-2558-977150CA06B2}"/>
                </a:ext>
              </a:extLst>
            </p:cNvPr>
            <p:cNvSpPr txBox="1"/>
            <p:nvPr/>
          </p:nvSpPr>
          <p:spPr>
            <a:xfrm>
              <a:off x="1653891" y="3209670"/>
              <a:ext cx="446917" cy="3505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线连接符 13">
              <a:extLst>
                <a:ext uri="{FF2B5EF4-FFF2-40B4-BE49-F238E27FC236}">
                  <a16:creationId xmlns:a16="http://schemas.microsoft.com/office/drawing/2014/main" id="{E9F43420-1E83-C918-B42F-7C45EFCEA648}"/>
                </a:ext>
              </a:extLst>
            </p:cNvPr>
            <p:cNvCxnSpPr>
              <a:cxnSpLocks/>
            </p:cNvCxnSpPr>
            <p:nvPr/>
          </p:nvCxnSpPr>
          <p:spPr>
            <a:xfrm>
              <a:off x="2071535" y="3397190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线连接符 14">
              <a:extLst>
                <a:ext uri="{FF2B5EF4-FFF2-40B4-BE49-F238E27FC236}">
                  <a16:creationId xmlns:a16="http://schemas.microsoft.com/office/drawing/2014/main" id="{2109B567-2077-6B81-5952-C4B484E75745}"/>
                </a:ext>
              </a:extLst>
            </p:cNvPr>
            <p:cNvCxnSpPr>
              <a:cxnSpLocks/>
            </p:cNvCxnSpPr>
            <p:nvPr/>
          </p:nvCxnSpPr>
          <p:spPr>
            <a:xfrm>
              <a:off x="2071535" y="2890332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FE40CD56-DF73-F0CA-B0A4-3AC80B9A4230}"/>
                </a:ext>
              </a:extLst>
            </p:cNvPr>
            <p:cNvSpPr txBox="1"/>
            <p:nvPr/>
          </p:nvSpPr>
          <p:spPr>
            <a:xfrm>
              <a:off x="1653891" y="2724310"/>
              <a:ext cx="446917" cy="3505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C175B85C-D47C-C04F-2CB1-5BBB35172CAB}"/>
                </a:ext>
              </a:extLst>
            </p:cNvPr>
            <p:cNvSpPr txBox="1"/>
            <p:nvPr/>
          </p:nvSpPr>
          <p:spPr>
            <a:xfrm>
              <a:off x="5554388" y="2607087"/>
              <a:ext cx="927665" cy="4342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0AC5831C-6435-1F7B-E13B-7FDC47D239E6}"/>
                </a:ext>
              </a:extLst>
            </p:cNvPr>
            <p:cNvGrpSpPr/>
            <p:nvPr/>
          </p:nvGrpSpPr>
          <p:grpSpPr>
            <a:xfrm>
              <a:off x="2743200" y="1746580"/>
              <a:ext cx="2147732" cy="434256"/>
              <a:chOff x="3965831" y="3305229"/>
              <a:chExt cx="1033486" cy="226766"/>
            </a:xfrm>
          </p:grpSpPr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41B51AF4-9E86-9550-BC83-F7306A96BE4C}"/>
                  </a:ext>
                </a:extLst>
              </p:cNvPr>
              <p:cNvSpPr txBox="1"/>
              <p:nvPr/>
            </p:nvSpPr>
            <p:spPr>
              <a:xfrm>
                <a:off x="3965831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6AA4B2C9-006B-EDD2-0A2A-29D0E1862BA7}"/>
                  </a:ext>
                </a:extLst>
              </p:cNvPr>
              <p:cNvSpPr txBox="1"/>
              <p:nvPr/>
            </p:nvSpPr>
            <p:spPr>
              <a:xfrm>
                <a:off x="4272728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A9549F8A-C2E5-4963-D632-CF2F709DAA12}"/>
                  </a:ext>
                </a:extLst>
              </p:cNvPr>
              <p:cNvSpPr txBox="1"/>
              <p:nvPr/>
            </p:nvSpPr>
            <p:spPr>
              <a:xfrm>
                <a:off x="4553599" y="3305229"/>
                <a:ext cx="157513" cy="2089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3485C6A9-A6ED-8726-D792-C623AE02413D}"/>
                  </a:ext>
                </a:extLst>
              </p:cNvPr>
              <p:cNvSpPr txBox="1"/>
              <p:nvPr/>
            </p:nvSpPr>
            <p:spPr>
              <a:xfrm>
                <a:off x="4841804" y="3305229"/>
                <a:ext cx="157513" cy="2089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" name="直线连接符 5">
              <a:extLst>
                <a:ext uri="{FF2B5EF4-FFF2-40B4-BE49-F238E27FC236}">
                  <a16:creationId xmlns:a16="http://schemas.microsoft.com/office/drawing/2014/main" id="{A56B27AC-A569-B045-42F2-4F4DE5D64117}"/>
                </a:ext>
              </a:extLst>
            </p:cNvPr>
            <p:cNvCxnSpPr>
              <a:cxnSpLocks/>
            </p:cNvCxnSpPr>
            <p:nvPr/>
          </p:nvCxnSpPr>
          <p:spPr>
            <a:xfrm>
              <a:off x="2071535" y="2504353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BC154FB6-1B40-5A8A-34DF-B22ED9624096}"/>
                </a:ext>
              </a:extLst>
            </p:cNvPr>
            <p:cNvSpPr txBox="1"/>
            <p:nvPr/>
          </p:nvSpPr>
          <p:spPr>
            <a:xfrm>
              <a:off x="1653891" y="2331392"/>
              <a:ext cx="446917" cy="3505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A621F097-FC54-EBF8-A453-2F34CA7C98AB}"/>
              </a:ext>
            </a:extLst>
          </p:cNvPr>
          <p:cNvSpPr txBox="1"/>
          <p:nvPr/>
        </p:nvSpPr>
        <p:spPr>
          <a:xfrm>
            <a:off x="5619967" y="819805"/>
            <a:ext cx="142539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E6E79007-CDA7-8F89-E84D-EF72A95737F0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54CBFD7B-1527-3136-C55B-EF7437F56BCF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CCB0C302-DB48-CD25-CA14-1D9CBD82794F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78669106-F27F-4C84-DD9D-E58CB408F5C7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6EE17D31-8274-5156-B43B-305970B0E8B7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C687361A-3C96-30FF-C8DD-E8E6D822A255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5A8D4B9D-56E4-77F4-0175-2F67A459E4F5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D66B124B-8528-34D0-ADC7-C6804B8E959F}"/>
              </a:ext>
            </a:extLst>
          </p:cNvPr>
          <p:cNvGrpSpPr/>
          <p:nvPr/>
        </p:nvGrpSpPr>
        <p:grpSpPr>
          <a:xfrm>
            <a:off x="6633801" y="2009307"/>
            <a:ext cx="5073648" cy="1745484"/>
            <a:chOff x="6760801" y="1753328"/>
            <a:chExt cx="5073648" cy="1745484"/>
          </a:xfrm>
        </p:grpSpPr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BD6928B7-89A3-4087-237E-B12461104FE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7467641" y="2161471"/>
              <a:ext cx="3372852" cy="1337341"/>
            </a:xfrm>
            <a:prstGeom prst="rect">
              <a:avLst/>
            </a:prstGeom>
          </p:spPr>
        </p:pic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5224E80C-6FF4-C0C0-3A83-DE8156E6099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760801" y="1753328"/>
              <a:ext cx="5073648" cy="1274921"/>
              <a:chOff x="8019826" y="3008119"/>
              <a:chExt cx="2793083" cy="701852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62E3038D-5071-6FAE-F4FE-78B830A16093}"/>
                  </a:ext>
                </a:extLst>
              </p:cNvPr>
              <p:cNvSpPr txBox="1"/>
              <p:nvPr/>
            </p:nvSpPr>
            <p:spPr>
              <a:xfrm>
                <a:off x="8019826" y="3476511"/>
                <a:ext cx="440520" cy="2027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GAS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0" name="组合 59">
                <a:extLst>
                  <a:ext uri="{FF2B5EF4-FFF2-40B4-BE49-F238E27FC236}">
                    <a16:creationId xmlns:a16="http://schemas.microsoft.com/office/drawing/2014/main" id="{C9FD3247-CEC5-FF8D-7572-C994FDF8F512}"/>
                  </a:ext>
                </a:extLst>
              </p:cNvPr>
              <p:cNvGrpSpPr/>
              <p:nvPr/>
            </p:nvGrpSpPr>
            <p:grpSpPr>
              <a:xfrm>
                <a:off x="8739864" y="3008119"/>
                <a:ext cx="1192234" cy="220267"/>
                <a:chOff x="3869828" y="3233578"/>
                <a:chExt cx="1192234" cy="220267"/>
              </a:xfrm>
            </p:grpSpPr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97AA6111-91F3-C9C4-37CB-6C20C22B788D}"/>
                    </a:ext>
                  </a:extLst>
                </p:cNvPr>
                <p:cNvSpPr txBox="1"/>
                <p:nvPr/>
              </p:nvSpPr>
              <p:spPr>
                <a:xfrm>
                  <a:off x="3869828" y="3233578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31523009-DB2C-B457-09F9-FBCC5832B8BC}"/>
                    </a:ext>
                  </a:extLst>
                </p:cNvPr>
                <p:cNvSpPr txBox="1"/>
                <p:nvPr/>
              </p:nvSpPr>
              <p:spPr>
                <a:xfrm>
                  <a:off x="4231149" y="3233581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C7D0DE6C-4F5D-3BE2-4821-C748EB4C1587}"/>
                    </a:ext>
                  </a:extLst>
                </p:cNvPr>
                <p:cNvSpPr txBox="1"/>
                <p:nvPr/>
              </p:nvSpPr>
              <p:spPr>
                <a:xfrm>
                  <a:off x="4557369" y="3233581"/>
                  <a:ext cx="180200" cy="2202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66ED24C2-B0FF-33E2-E4F6-1C49ECCD5F95}"/>
                    </a:ext>
                  </a:extLst>
                </p:cNvPr>
                <p:cNvSpPr txBox="1"/>
                <p:nvPr/>
              </p:nvSpPr>
              <p:spPr>
                <a:xfrm>
                  <a:off x="4881862" y="3233581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A7EB8CA3-C34D-CFC2-484A-DBB6E00B40D3}"/>
                  </a:ext>
                </a:extLst>
              </p:cNvPr>
              <p:cNvSpPr txBox="1"/>
              <p:nvPr/>
            </p:nvSpPr>
            <p:spPr>
              <a:xfrm>
                <a:off x="10342379" y="3489707"/>
                <a:ext cx="47053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6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2" name="图片 1">
            <a:extLst>
              <a:ext uri="{FF2B5EF4-FFF2-40B4-BE49-F238E27FC236}">
                <a16:creationId xmlns:a16="http://schemas.microsoft.com/office/drawing/2014/main" id="{483732CC-C14D-1429-019B-26D6D89EAF8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493041" y="2569850"/>
            <a:ext cx="3372852" cy="13373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77317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E893A3-FDA3-E771-91A3-574C7461CA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CCD4E3E1-AE50-D525-1232-440AB6C648AE}"/>
              </a:ext>
            </a:extLst>
          </p:cNvPr>
          <p:cNvGrpSpPr/>
          <p:nvPr/>
        </p:nvGrpSpPr>
        <p:grpSpPr>
          <a:xfrm>
            <a:off x="7051318" y="1753319"/>
            <a:ext cx="4683193" cy="1823333"/>
            <a:chOff x="7051318" y="1753319"/>
            <a:chExt cx="4683193" cy="1823333"/>
          </a:xfrm>
        </p:grpSpPr>
        <p:pic>
          <p:nvPicPr>
            <p:cNvPr id="3" name="图片 2" descr="人的脸&#10;&#10;AI 生成的内容可能不正确。">
              <a:extLst>
                <a:ext uri="{FF2B5EF4-FFF2-40B4-BE49-F238E27FC236}">
                  <a16:creationId xmlns:a16="http://schemas.microsoft.com/office/drawing/2014/main" id="{1E6D2177-6BE2-1C3D-FC34-7573646AA0C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7777905" y="2142446"/>
              <a:ext cx="2917645" cy="1434206"/>
            </a:xfrm>
            <a:prstGeom prst="rect">
              <a:avLst/>
            </a:prstGeom>
          </p:spPr>
        </p:pic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950919FF-E128-2EB9-43CC-58D43919087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051318" y="1753319"/>
              <a:ext cx="4683193" cy="1285500"/>
              <a:chOff x="8179755" y="3008119"/>
              <a:chExt cx="2578133" cy="707677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8FA18111-BA4F-7D2C-2333-4B7150C9C8E6}"/>
                  </a:ext>
                </a:extLst>
              </p:cNvPr>
              <p:cNvSpPr txBox="1"/>
              <p:nvPr/>
            </p:nvSpPr>
            <p:spPr>
              <a:xfrm>
                <a:off x="8179755" y="3482339"/>
                <a:ext cx="353163" cy="220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Gli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614EAACF-B3AF-61B9-26B1-11AD99555117}"/>
                  </a:ext>
                </a:extLst>
              </p:cNvPr>
              <p:cNvSpPr txBox="1"/>
              <p:nvPr/>
            </p:nvSpPr>
            <p:spPr>
              <a:xfrm>
                <a:off x="10208818" y="3495533"/>
                <a:ext cx="549070" cy="220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60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0" name="组合 59">
                <a:extLst>
                  <a:ext uri="{FF2B5EF4-FFF2-40B4-BE49-F238E27FC236}">
                    <a16:creationId xmlns:a16="http://schemas.microsoft.com/office/drawing/2014/main" id="{7483A34F-69EE-D9B0-259B-D25D79CEDA7D}"/>
                  </a:ext>
                </a:extLst>
              </p:cNvPr>
              <p:cNvGrpSpPr/>
              <p:nvPr/>
            </p:nvGrpSpPr>
            <p:grpSpPr>
              <a:xfrm>
                <a:off x="8789749" y="3008119"/>
                <a:ext cx="1056184" cy="220267"/>
                <a:chOff x="3919713" y="3233578"/>
                <a:chExt cx="1056184" cy="220267"/>
              </a:xfrm>
            </p:grpSpPr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7B7A9A36-F48D-6B18-1E74-479EB60D97AD}"/>
                    </a:ext>
                  </a:extLst>
                </p:cNvPr>
                <p:cNvSpPr txBox="1"/>
                <p:nvPr/>
              </p:nvSpPr>
              <p:spPr>
                <a:xfrm>
                  <a:off x="3919713" y="3233578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539F941A-CE92-CDA2-8414-D3F405BB1740}"/>
                    </a:ext>
                  </a:extLst>
                </p:cNvPr>
                <p:cNvSpPr txBox="1"/>
                <p:nvPr/>
              </p:nvSpPr>
              <p:spPr>
                <a:xfrm>
                  <a:off x="4226614" y="3233581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87159D34-6C15-06D0-6034-EEDBECAAD97A}"/>
                    </a:ext>
                  </a:extLst>
                </p:cNvPr>
                <p:cNvSpPr txBox="1"/>
                <p:nvPr/>
              </p:nvSpPr>
              <p:spPr>
                <a:xfrm>
                  <a:off x="4507484" y="3233581"/>
                  <a:ext cx="180200" cy="2202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0B7AD484-040A-066E-8998-E7B14FF7C278}"/>
                    </a:ext>
                  </a:extLst>
                </p:cNvPr>
                <p:cNvSpPr txBox="1"/>
                <p:nvPr/>
              </p:nvSpPr>
              <p:spPr>
                <a:xfrm>
                  <a:off x="4795697" y="3233581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5932F976-F94A-200C-DEBB-2BE7B648BE9C}"/>
              </a:ext>
            </a:extLst>
          </p:cNvPr>
          <p:cNvSpPr txBox="1"/>
          <p:nvPr/>
        </p:nvSpPr>
        <p:spPr>
          <a:xfrm>
            <a:off x="5619967" y="819805"/>
            <a:ext cx="12971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D2BACE08-C89A-ABA1-9773-6E1D1101572A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72AE7697-A794-AC54-9EB4-5CC971FF579B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9907F06D-F55F-C6F9-904C-FC9842247145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6B72B90F-B59C-55D2-80E6-67C20873052E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75FE4237-1D33-9FD7-1D3E-96D3E71C27E8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C2739E59-257A-6198-6089-FB7BB27BB01E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02F6A5B6-1EC3-253E-7A01-8F27A7AD483B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4F0A98E4-3009-521C-0114-767A04DF1FA1}"/>
              </a:ext>
            </a:extLst>
          </p:cNvPr>
          <p:cNvGrpSpPr/>
          <p:nvPr/>
        </p:nvGrpSpPr>
        <p:grpSpPr>
          <a:xfrm>
            <a:off x="770038" y="1746580"/>
            <a:ext cx="5568228" cy="1896226"/>
            <a:chOff x="770038" y="1746580"/>
            <a:chExt cx="5568228" cy="1896226"/>
          </a:xfrm>
        </p:grpSpPr>
        <p:pic>
          <p:nvPicPr>
            <p:cNvPr id="11" name="图片 10" descr="图片包含 照片, 屏幕, 监控, 电视&#10;&#10;AI 生成的内容可能不正确。">
              <a:extLst>
                <a:ext uri="{FF2B5EF4-FFF2-40B4-BE49-F238E27FC236}">
                  <a16:creationId xmlns:a16="http://schemas.microsoft.com/office/drawing/2014/main" id="{FCCBD29F-F624-5F10-B322-8D0B710B9AB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2286922" y="2208600"/>
              <a:ext cx="3064032" cy="1434206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B77066A5-5AE7-EEE3-6092-CC148493C3A8}"/>
                </a:ext>
              </a:extLst>
            </p:cNvPr>
            <p:cNvSpPr txBox="1"/>
            <p:nvPr/>
          </p:nvSpPr>
          <p:spPr>
            <a:xfrm>
              <a:off x="770038" y="2757385"/>
              <a:ext cx="64152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Gli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93F910DB-7E5C-FEEE-8801-C644499CE156}"/>
                </a:ext>
              </a:extLst>
            </p:cNvPr>
            <p:cNvSpPr txBox="1"/>
            <p:nvPr/>
          </p:nvSpPr>
          <p:spPr>
            <a:xfrm>
              <a:off x="1759353" y="3080634"/>
              <a:ext cx="399468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直线连接符 13">
              <a:extLst>
                <a:ext uri="{FF2B5EF4-FFF2-40B4-BE49-F238E27FC236}">
                  <a16:creationId xmlns:a16="http://schemas.microsoft.com/office/drawing/2014/main" id="{AF58890E-8152-1877-3DA4-5935A7CF798D}"/>
                </a:ext>
              </a:extLst>
            </p:cNvPr>
            <p:cNvCxnSpPr>
              <a:cxnSpLocks/>
            </p:cNvCxnSpPr>
            <p:nvPr/>
          </p:nvCxnSpPr>
          <p:spPr>
            <a:xfrm>
              <a:off x="2170512" y="3249682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线连接符 14">
              <a:extLst>
                <a:ext uri="{FF2B5EF4-FFF2-40B4-BE49-F238E27FC236}">
                  <a16:creationId xmlns:a16="http://schemas.microsoft.com/office/drawing/2014/main" id="{BDFEBDA8-298D-5902-E351-AA072B3ECDDE}"/>
                </a:ext>
              </a:extLst>
            </p:cNvPr>
            <p:cNvCxnSpPr>
              <a:cxnSpLocks/>
            </p:cNvCxnSpPr>
            <p:nvPr/>
          </p:nvCxnSpPr>
          <p:spPr>
            <a:xfrm>
              <a:off x="2170512" y="3012202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D7B07101-92AD-7238-32BE-45EFC975C4DA}"/>
                </a:ext>
              </a:extLst>
            </p:cNvPr>
            <p:cNvSpPr txBox="1"/>
            <p:nvPr/>
          </p:nvSpPr>
          <p:spPr>
            <a:xfrm>
              <a:off x="1660505" y="2848250"/>
              <a:ext cx="506870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B9F0E437-FEA4-F43B-5ED9-689FB48330F1}"/>
                </a:ext>
              </a:extLst>
            </p:cNvPr>
            <p:cNvSpPr txBox="1"/>
            <p:nvPr/>
          </p:nvSpPr>
          <p:spPr>
            <a:xfrm>
              <a:off x="5340877" y="2757385"/>
              <a:ext cx="9973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60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组合 20">
              <a:extLst>
                <a:ext uri="{FF2B5EF4-FFF2-40B4-BE49-F238E27FC236}">
                  <a16:creationId xmlns:a16="http://schemas.microsoft.com/office/drawing/2014/main" id="{61B3C0C2-8E70-AEB1-8033-6DA05E777F54}"/>
                </a:ext>
              </a:extLst>
            </p:cNvPr>
            <p:cNvGrpSpPr/>
            <p:nvPr/>
          </p:nvGrpSpPr>
          <p:grpSpPr>
            <a:xfrm>
              <a:off x="2743200" y="1746580"/>
              <a:ext cx="2147732" cy="434256"/>
              <a:chOff x="3965831" y="3305229"/>
              <a:chExt cx="1033486" cy="226766"/>
            </a:xfrm>
          </p:grpSpPr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929DF33F-AAEE-C06F-96F2-AEF061112224}"/>
                  </a:ext>
                </a:extLst>
              </p:cNvPr>
              <p:cNvSpPr txBox="1"/>
              <p:nvPr/>
            </p:nvSpPr>
            <p:spPr>
              <a:xfrm>
                <a:off x="3965831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5DA3025A-A8B0-A787-EE2E-BAC2ACF3B2FB}"/>
                  </a:ext>
                </a:extLst>
              </p:cNvPr>
              <p:cNvSpPr txBox="1"/>
              <p:nvPr/>
            </p:nvSpPr>
            <p:spPr>
              <a:xfrm>
                <a:off x="4272728" y="3305229"/>
                <a:ext cx="170955" cy="2267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47E22F33-19B6-15EE-AFD4-CCFB85F446C3}"/>
                  </a:ext>
                </a:extLst>
              </p:cNvPr>
              <p:cNvSpPr txBox="1"/>
              <p:nvPr/>
            </p:nvSpPr>
            <p:spPr>
              <a:xfrm>
                <a:off x="4553599" y="3305229"/>
                <a:ext cx="157513" cy="2089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DC1CC40C-328B-6C66-9758-98CA18B57D07}"/>
                  </a:ext>
                </a:extLst>
              </p:cNvPr>
              <p:cNvSpPr txBox="1"/>
              <p:nvPr/>
            </p:nvSpPr>
            <p:spPr>
              <a:xfrm>
                <a:off x="4841804" y="3305229"/>
                <a:ext cx="157513" cy="2089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6" name="直线连接符 5">
              <a:extLst>
                <a:ext uri="{FF2B5EF4-FFF2-40B4-BE49-F238E27FC236}">
                  <a16:creationId xmlns:a16="http://schemas.microsoft.com/office/drawing/2014/main" id="{1F811E6A-4782-F2C0-BF23-059A60093AE4}"/>
                </a:ext>
              </a:extLst>
            </p:cNvPr>
            <p:cNvCxnSpPr>
              <a:cxnSpLocks/>
            </p:cNvCxnSpPr>
            <p:nvPr/>
          </p:nvCxnSpPr>
          <p:spPr>
            <a:xfrm>
              <a:off x="2170512" y="2726741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54A3F5DC-0505-B52B-18DB-2D35EC835A67}"/>
                </a:ext>
              </a:extLst>
            </p:cNvPr>
            <p:cNvSpPr txBox="1"/>
            <p:nvPr/>
          </p:nvSpPr>
          <p:spPr>
            <a:xfrm>
              <a:off x="1660505" y="2564396"/>
              <a:ext cx="506870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线连接符 35">
              <a:extLst>
                <a:ext uri="{FF2B5EF4-FFF2-40B4-BE49-F238E27FC236}">
                  <a16:creationId xmlns:a16="http://schemas.microsoft.com/office/drawing/2014/main" id="{25831EF4-8339-62FC-24EE-C24C72A52B8B}"/>
                </a:ext>
              </a:extLst>
            </p:cNvPr>
            <p:cNvCxnSpPr>
              <a:cxnSpLocks/>
            </p:cNvCxnSpPr>
            <p:nvPr/>
          </p:nvCxnSpPr>
          <p:spPr>
            <a:xfrm>
              <a:off x="2170512" y="2472742"/>
              <a:ext cx="11222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11AA98CA-7DB8-2949-C5A5-27588F07E26B}"/>
                </a:ext>
              </a:extLst>
            </p:cNvPr>
            <p:cNvSpPr txBox="1"/>
            <p:nvPr/>
          </p:nvSpPr>
          <p:spPr>
            <a:xfrm>
              <a:off x="1660505" y="2308934"/>
              <a:ext cx="506870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5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kumimoji="1" lang="zh-CN" altLang="en-US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451402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F6C8B01-8DB8-500C-F9F2-2D5FE0E7DC2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>
            <a:extLst>
              <a:ext uri="{FF2B5EF4-FFF2-40B4-BE49-F238E27FC236}">
                <a16:creationId xmlns:a16="http://schemas.microsoft.com/office/drawing/2014/main" id="{FCB4F3D3-7C54-A68D-00BA-BD3EAAB8D26E}"/>
              </a:ext>
            </a:extLst>
          </p:cNvPr>
          <p:cNvGrpSpPr>
            <a:grpSpLocks noChangeAspect="1"/>
          </p:cNvGrpSpPr>
          <p:nvPr/>
        </p:nvGrpSpPr>
        <p:grpSpPr>
          <a:xfrm>
            <a:off x="6700529" y="1805811"/>
            <a:ext cx="4671183" cy="1727986"/>
            <a:chOff x="7282675" y="1999812"/>
            <a:chExt cx="4007783" cy="1308887"/>
          </a:xfrm>
        </p:grpSpPr>
        <p:pic>
          <p:nvPicPr>
            <p:cNvPr id="26" name="图片 25">
              <a:extLst>
                <a:ext uri="{FF2B5EF4-FFF2-40B4-BE49-F238E27FC236}">
                  <a16:creationId xmlns:a16="http://schemas.microsoft.com/office/drawing/2014/main" id="{4107FD78-B1F7-9D1D-CE49-C04CA894F6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7767287" y="2392882"/>
              <a:ext cx="2935082" cy="915817"/>
            </a:xfrm>
            <a:prstGeom prst="rect">
              <a:avLst/>
            </a:prstGeom>
          </p:spPr>
        </p:pic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ADE4C76C-DB22-594E-5C90-56A1D57CA49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282675" y="1999812"/>
              <a:ext cx="4007783" cy="1072590"/>
              <a:chOff x="8307125" y="3008119"/>
              <a:chExt cx="2206316" cy="590468"/>
            </a:xfrm>
          </p:grpSpPr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4FA9221F-A475-8567-8F37-F7A07AAC6E57}"/>
                  </a:ext>
                </a:extLst>
              </p:cNvPr>
              <p:cNvSpPr txBox="1"/>
              <p:nvPr/>
            </p:nvSpPr>
            <p:spPr>
              <a:xfrm>
                <a:off x="8307125" y="3378323"/>
                <a:ext cx="353163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Gli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1E1039C7-C4D5-370F-5720-7A4C62FC5442}"/>
                  </a:ext>
                </a:extLst>
              </p:cNvPr>
              <p:cNvSpPr txBox="1"/>
              <p:nvPr/>
            </p:nvSpPr>
            <p:spPr>
              <a:xfrm>
                <a:off x="10042349" y="3370625"/>
                <a:ext cx="471092" cy="16684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60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0" name="组合 59">
                <a:extLst>
                  <a:ext uri="{FF2B5EF4-FFF2-40B4-BE49-F238E27FC236}">
                    <a16:creationId xmlns:a16="http://schemas.microsoft.com/office/drawing/2014/main" id="{41FE6E59-EB87-F17D-9160-4DCC639EB6D9}"/>
                  </a:ext>
                </a:extLst>
              </p:cNvPr>
              <p:cNvGrpSpPr/>
              <p:nvPr/>
            </p:nvGrpSpPr>
            <p:grpSpPr>
              <a:xfrm>
                <a:off x="8821212" y="3008119"/>
                <a:ext cx="1056183" cy="220267"/>
                <a:chOff x="3951176" y="3233578"/>
                <a:chExt cx="1056183" cy="220267"/>
              </a:xfrm>
            </p:grpSpPr>
            <p:sp>
              <p:nvSpPr>
                <p:cNvPr id="65" name="文本框 64">
                  <a:extLst>
                    <a:ext uri="{FF2B5EF4-FFF2-40B4-BE49-F238E27FC236}">
                      <a16:creationId xmlns:a16="http://schemas.microsoft.com/office/drawing/2014/main" id="{DE22C27A-A232-0060-3197-82E6A4F4ECC0}"/>
                    </a:ext>
                  </a:extLst>
                </p:cNvPr>
                <p:cNvSpPr txBox="1"/>
                <p:nvPr/>
              </p:nvSpPr>
              <p:spPr>
                <a:xfrm>
                  <a:off x="3951176" y="3233578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文本框 65">
                  <a:extLst>
                    <a:ext uri="{FF2B5EF4-FFF2-40B4-BE49-F238E27FC236}">
                      <a16:creationId xmlns:a16="http://schemas.microsoft.com/office/drawing/2014/main" id="{F68A22CD-49C2-5E0B-43AF-98E003A7254D}"/>
                    </a:ext>
                  </a:extLst>
                </p:cNvPr>
                <p:cNvSpPr txBox="1"/>
                <p:nvPr/>
              </p:nvSpPr>
              <p:spPr>
                <a:xfrm>
                  <a:off x="4258075" y="3233581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文本框 66">
                  <a:extLst>
                    <a:ext uri="{FF2B5EF4-FFF2-40B4-BE49-F238E27FC236}">
                      <a16:creationId xmlns:a16="http://schemas.microsoft.com/office/drawing/2014/main" id="{5530184A-E18B-DE07-DC3B-905B27319D48}"/>
                    </a:ext>
                  </a:extLst>
                </p:cNvPr>
                <p:cNvSpPr txBox="1"/>
                <p:nvPr/>
              </p:nvSpPr>
              <p:spPr>
                <a:xfrm>
                  <a:off x="4538947" y="3233581"/>
                  <a:ext cx="180200" cy="22026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4EDE34F3-3AA2-07AE-A2AE-AD73A9BC2E66}"/>
                    </a:ext>
                  </a:extLst>
                </p:cNvPr>
                <p:cNvSpPr txBox="1"/>
                <p:nvPr/>
              </p:nvSpPr>
              <p:spPr>
                <a:xfrm>
                  <a:off x="4827159" y="3233581"/>
                  <a:ext cx="180200" cy="2202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</a:t>
                  </a:r>
                  <a:endPara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E299E219-B091-8F33-DF4D-3CEFB681BD32}"/>
              </a:ext>
            </a:extLst>
          </p:cNvPr>
          <p:cNvSpPr txBox="1"/>
          <p:nvPr/>
        </p:nvSpPr>
        <p:spPr>
          <a:xfrm>
            <a:off x="5619967" y="819805"/>
            <a:ext cx="142539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57F9BDC8-1922-59CA-6DB1-F300B51BB5BB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24B46E78-B2B6-107C-B53F-0893D356C93A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1976AFA9-B9A5-67AC-7A12-071A83DF120E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CCC9E442-A951-8CB1-CC2E-7F9227DF3586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36D1EF45-E7C6-673C-4EE1-68DF869D929C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7E084FC6-C45D-BAA0-530E-7BA70020B8B0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CF79C81B-D418-6CE0-A8F7-5D09EE9D9844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5" name="图片 4">
            <a:extLst>
              <a:ext uri="{FF2B5EF4-FFF2-40B4-BE49-F238E27FC236}">
                <a16:creationId xmlns:a16="http://schemas.microsoft.com/office/drawing/2014/main" id="{BE3A99D9-C9CD-2F93-54E5-77C9F560AA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998935" y="2429744"/>
            <a:ext cx="3478361" cy="113278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9FDAA9D0-10B0-8EC4-AE2C-777FDA9D2C7A}"/>
              </a:ext>
            </a:extLst>
          </p:cNvPr>
          <p:cNvSpPr txBox="1"/>
          <p:nvPr/>
        </p:nvSpPr>
        <p:spPr>
          <a:xfrm>
            <a:off x="767732" y="2707268"/>
            <a:ext cx="709484" cy="4908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Gli1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E51163C-C0D7-ABE3-B66E-CED7843559B2}"/>
              </a:ext>
            </a:extLst>
          </p:cNvPr>
          <p:cNvSpPr txBox="1"/>
          <p:nvPr/>
        </p:nvSpPr>
        <p:spPr>
          <a:xfrm>
            <a:off x="1440904" y="2785583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线连接符 13">
            <a:extLst>
              <a:ext uri="{FF2B5EF4-FFF2-40B4-BE49-F238E27FC236}">
                <a16:creationId xmlns:a16="http://schemas.microsoft.com/office/drawing/2014/main" id="{6D974BB6-4509-0371-4F58-B31A72A78205}"/>
              </a:ext>
            </a:extLst>
          </p:cNvPr>
          <p:cNvCxnSpPr>
            <a:cxnSpLocks/>
          </p:cNvCxnSpPr>
          <p:nvPr/>
        </p:nvCxnSpPr>
        <p:spPr>
          <a:xfrm>
            <a:off x="1908009" y="3275086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4E11A899-B787-23E2-36B1-3D17B7D2F636}"/>
              </a:ext>
            </a:extLst>
          </p:cNvPr>
          <p:cNvCxnSpPr>
            <a:cxnSpLocks/>
          </p:cNvCxnSpPr>
          <p:nvPr/>
        </p:nvCxnSpPr>
        <p:spPr>
          <a:xfrm>
            <a:off x="1908009" y="2952974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586100C9-A8C1-47F8-1604-33110A63B493}"/>
              </a:ext>
            </a:extLst>
          </p:cNvPr>
          <p:cNvSpPr txBox="1"/>
          <p:nvPr/>
        </p:nvSpPr>
        <p:spPr>
          <a:xfrm>
            <a:off x="1440904" y="2525603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1484389-3C95-6999-4D53-63929AE209F4}"/>
              </a:ext>
            </a:extLst>
          </p:cNvPr>
          <p:cNvSpPr txBox="1"/>
          <p:nvPr/>
        </p:nvSpPr>
        <p:spPr>
          <a:xfrm>
            <a:off x="5150731" y="2707268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160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5762230E-58B4-57EA-4D4C-B3EB58532608}"/>
              </a:ext>
            </a:extLst>
          </p:cNvPr>
          <p:cNvGrpSpPr/>
          <p:nvPr/>
        </p:nvGrpSpPr>
        <p:grpSpPr>
          <a:xfrm>
            <a:off x="2523455" y="1910913"/>
            <a:ext cx="2375261" cy="532751"/>
            <a:chOff x="3965831" y="3305229"/>
            <a:chExt cx="1033486" cy="226766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ACE18DCA-44FC-1012-C170-FA693D034F24}"/>
                </a:ext>
              </a:extLst>
            </p:cNvPr>
            <p:cNvSpPr txBox="1"/>
            <p:nvPr/>
          </p:nvSpPr>
          <p:spPr>
            <a:xfrm>
              <a:off x="3965831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5E348036-D409-4154-0250-1BE8404A6684}"/>
                </a:ext>
              </a:extLst>
            </p:cNvPr>
            <p:cNvSpPr txBox="1"/>
            <p:nvPr/>
          </p:nvSpPr>
          <p:spPr>
            <a:xfrm>
              <a:off x="42727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9990674F-C091-B23C-AA04-8716C3BE7389}"/>
                </a:ext>
              </a:extLst>
            </p:cNvPr>
            <p:cNvSpPr txBox="1"/>
            <p:nvPr/>
          </p:nvSpPr>
          <p:spPr>
            <a:xfrm>
              <a:off x="4553599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9F35B09D-5F70-6DDA-5705-74D4874534E1}"/>
                </a:ext>
              </a:extLst>
            </p:cNvPr>
            <p:cNvSpPr txBox="1"/>
            <p:nvPr/>
          </p:nvSpPr>
          <p:spPr>
            <a:xfrm>
              <a:off x="4841804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" name="直线连接符 5">
            <a:extLst>
              <a:ext uri="{FF2B5EF4-FFF2-40B4-BE49-F238E27FC236}">
                <a16:creationId xmlns:a16="http://schemas.microsoft.com/office/drawing/2014/main" id="{A2F6D52C-A307-24A1-73CC-300C5ACEE902}"/>
              </a:ext>
            </a:extLst>
          </p:cNvPr>
          <p:cNvCxnSpPr>
            <a:cxnSpLocks/>
          </p:cNvCxnSpPr>
          <p:nvPr/>
        </p:nvCxnSpPr>
        <p:spPr>
          <a:xfrm>
            <a:off x="1908009" y="2685762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直线连接符 37">
            <a:extLst>
              <a:ext uri="{FF2B5EF4-FFF2-40B4-BE49-F238E27FC236}">
                <a16:creationId xmlns:a16="http://schemas.microsoft.com/office/drawing/2014/main" id="{C7FFA803-1EF6-195C-6077-AB5FFBF5D8A2}"/>
              </a:ext>
            </a:extLst>
          </p:cNvPr>
          <p:cNvCxnSpPr>
            <a:cxnSpLocks/>
          </p:cNvCxnSpPr>
          <p:nvPr/>
        </p:nvCxnSpPr>
        <p:spPr>
          <a:xfrm>
            <a:off x="1908009" y="3519070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9F54CADA-90CF-2C44-C9AD-5ACAA794233B}"/>
              </a:ext>
            </a:extLst>
          </p:cNvPr>
          <p:cNvSpPr txBox="1"/>
          <p:nvPr/>
        </p:nvSpPr>
        <p:spPr>
          <a:xfrm>
            <a:off x="1440904" y="3108536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71F5EE0-FDA7-4250-4908-B9D3823504A1}"/>
              </a:ext>
            </a:extLst>
          </p:cNvPr>
          <p:cNvSpPr txBox="1"/>
          <p:nvPr/>
        </p:nvSpPr>
        <p:spPr>
          <a:xfrm>
            <a:off x="1535950" y="3348089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47680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92BB0F2-644B-7BA7-8A1B-E9F9A62B575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BC341CC-0FF4-6DCF-BE4E-DEF39B158CD0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6938984" y="1568657"/>
            <a:ext cx="4428665" cy="3029575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4DD4B975-A269-8ACB-8ED7-584F0131FC1B}"/>
              </a:ext>
            </a:extLst>
          </p:cNvPr>
          <p:cNvGrpSpPr>
            <a:grpSpLocks noChangeAspect="1"/>
          </p:cNvGrpSpPr>
          <p:nvPr/>
        </p:nvGrpSpPr>
        <p:grpSpPr>
          <a:xfrm>
            <a:off x="7051318" y="1977268"/>
            <a:ext cx="4288341" cy="1251266"/>
            <a:chOff x="8179755" y="3008119"/>
            <a:chExt cx="2360764" cy="688830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64F38E07-6BE8-3543-9EE5-BA9AD76B5E60}"/>
                </a:ext>
              </a:extLst>
            </p:cNvPr>
            <p:cNvSpPr txBox="1"/>
            <p:nvPr/>
          </p:nvSpPr>
          <p:spPr>
            <a:xfrm>
              <a:off x="8179755" y="3476686"/>
              <a:ext cx="400816" cy="2202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SHH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3A0E4530-D369-CF40-5E4C-9B55998D98E4}"/>
                </a:ext>
              </a:extLst>
            </p:cNvPr>
            <p:cNvSpPr txBox="1"/>
            <p:nvPr/>
          </p:nvSpPr>
          <p:spPr>
            <a:xfrm>
              <a:off x="10069989" y="3476686"/>
              <a:ext cx="470530" cy="2202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46EBC567-895B-7901-BE0A-39E139F33A48}"/>
                </a:ext>
              </a:extLst>
            </p:cNvPr>
            <p:cNvGrpSpPr/>
            <p:nvPr/>
          </p:nvGrpSpPr>
          <p:grpSpPr>
            <a:xfrm>
              <a:off x="8789749" y="3008119"/>
              <a:ext cx="1056184" cy="220267"/>
              <a:chOff x="3919713" y="3233578"/>
              <a:chExt cx="1056184" cy="220267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9ED42890-D3D2-ED32-A1CB-06C575C67F40}"/>
                  </a:ext>
                </a:extLst>
              </p:cNvPr>
              <p:cNvSpPr txBox="1"/>
              <p:nvPr/>
            </p:nvSpPr>
            <p:spPr>
              <a:xfrm>
                <a:off x="3919713" y="3233578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15ED80C2-FEEF-6B56-696E-5C2FA849438F}"/>
                  </a:ext>
                </a:extLst>
              </p:cNvPr>
              <p:cNvSpPr txBox="1"/>
              <p:nvPr/>
            </p:nvSpPr>
            <p:spPr>
              <a:xfrm>
                <a:off x="4226614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9C209BED-0E3B-16D5-624A-CFE3D492BF71}"/>
                  </a:ext>
                </a:extLst>
              </p:cNvPr>
              <p:cNvSpPr txBox="1"/>
              <p:nvPr/>
            </p:nvSpPr>
            <p:spPr>
              <a:xfrm>
                <a:off x="4507484" y="3233581"/>
                <a:ext cx="180200" cy="220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A0F61F0B-C75B-118A-E0C5-7B36F40BD9E1}"/>
                  </a:ext>
                </a:extLst>
              </p:cNvPr>
              <p:cNvSpPr txBox="1"/>
              <p:nvPr/>
            </p:nvSpPr>
            <p:spPr>
              <a:xfrm>
                <a:off x="4795697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85604CC6-AA48-5500-FE0E-7B7EAB3787B8}"/>
              </a:ext>
            </a:extLst>
          </p:cNvPr>
          <p:cNvSpPr txBox="1"/>
          <p:nvPr/>
        </p:nvSpPr>
        <p:spPr>
          <a:xfrm>
            <a:off x="985589" y="2753313"/>
            <a:ext cx="7280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HH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49EB9BDF-79D9-2BD9-C510-CCD59851F3E1}"/>
              </a:ext>
            </a:extLst>
          </p:cNvPr>
          <p:cNvSpPr txBox="1"/>
          <p:nvPr/>
        </p:nvSpPr>
        <p:spPr>
          <a:xfrm>
            <a:off x="1778350" y="3282756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线连接符 13">
            <a:extLst>
              <a:ext uri="{FF2B5EF4-FFF2-40B4-BE49-F238E27FC236}">
                <a16:creationId xmlns:a16="http://schemas.microsoft.com/office/drawing/2014/main" id="{72C7C2EB-C73C-C48D-2571-64519B5E31F8}"/>
              </a:ext>
            </a:extLst>
          </p:cNvPr>
          <p:cNvCxnSpPr>
            <a:cxnSpLocks/>
          </p:cNvCxnSpPr>
          <p:nvPr/>
        </p:nvCxnSpPr>
        <p:spPr>
          <a:xfrm>
            <a:off x="2146448" y="3438292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425E9BD0-689B-BEB0-2328-8E8699BABD74}"/>
              </a:ext>
            </a:extLst>
          </p:cNvPr>
          <p:cNvCxnSpPr>
            <a:cxnSpLocks/>
          </p:cNvCxnSpPr>
          <p:nvPr/>
        </p:nvCxnSpPr>
        <p:spPr>
          <a:xfrm>
            <a:off x="2146448" y="3181707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AA146794-0E30-8E17-C558-CEB1E5A3F890}"/>
              </a:ext>
            </a:extLst>
          </p:cNvPr>
          <p:cNvSpPr txBox="1"/>
          <p:nvPr/>
        </p:nvSpPr>
        <p:spPr>
          <a:xfrm>
            <a:off x="1778350" y="3017755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31B40D4-E999-79BB-3260-557F7CB3EA45}"/>
              </a:ext>
            </a:extLst>
          </p:cNvPr>
          <p:cNvSpPr txBox="1"/>
          <p:nvPr/>
        </p:nvSpPr>
        <p:spPr>
          <a:xfrm>
            <a:off x="5061477" y="2753313"/>
            <a:ext cx="8547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6C02E667-D343-377B-B8F9-0F61C76B4B32}"/>
              </a:ext>
            </a:extLst>
          </p:cNvPr>
          <p:cNvGrpSpPr/>
          <p:nvPr/>
        </p:nvGrpSpPr>
        <p:grpSpPr>
          <a:xfrm>
            <a:off x="2743200" y="1987431"/>
            <a:ext cx="2147732" cy="434256"/>
            <a:chOff x="3965831" y="3305229"/>
            <a:chExt cx="1033486" cy="226766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3377BB75-52A5-7754-973B-681378A13C1E}"/>
                </a:ext>
              </a:extLst>
            </p:cNvPr>
            <p:cNvSpPr txBox="1"/>
            <p:nvPr/>
          </p:nvSpPr>
          <p:spPr>
            <a:xfrm>
              <a:off x="3965831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C26F1A4A-7E32-5152-22BB-0B46B5FC6F51}"/>
                </a:ext>
              </a:extLst>
            </p:cNvPr>
            <p:cNvSpPr txBox="1"/>
            <p:nvPr/>
          </p:nvSpPr>
          <p:spPr>
            <a:xfrm>
              <a:off x="42727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2C038EB-0CBE-5F95-ADFF-180F02DDCE5E}"/>
                </a:ext>
              </a:extLst>
            </p:cNvPr>
            <p:cNvSpPr txBox="1"/>
            <p:nvPr/>
          </p:nvSpPr>
          <p:spPr>
            <a:xfrm>
              <a:off x="4553599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B57E0BC-ECBE-A92B-ECF6-B94DC0BB3F30}"/>
                </a:ext>
              </a:extLst>
            </p:cNvPr>
            <p:cNvSpPr txBox="1"/>
            <p:nvPr/>
          </p:nvSpPr>
          <p:spPr>
            <a:xfrm>
              <a:off x="4841804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" name="直线连接符 5">
            <a:extLst>
              <a:ext uri="{FF2B5EF4-FFF2-40B4-BE49-F238E27FC236}">
                <a16:creationId xmlns:a16="http://schemas.microsoft.com/office/drawing/2014/main" id="{46CCDCED-7549-DEC3-1D0A-CD329B58B808}"/>
              </a:ext>
            </a:extLst>
          </p:cNvPr>
          <p:cNvCxnSpPr>
            <a:cxnSpLocks/>
          </p:cNvCxnSpPr>
          <p:nvPr/>
        </p:nvCxnSpPr>
        <p:spPr>
          <a:xfrm>
            <a:off x="2146448" y="2910392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0A3BE1F3-8EE0-66AB-5DD8-F3C66BA4DFA6}"/>
              </a:ext>
            </a:extLst>
          </p:cNvPr>
          <p:cNvSpPr txBox="1"/>
          <p:nvPr/>
        </p:nvSpPr>
        <p:spPr>
          <a:xfrm>
            <a:off x="1778350" y="2748047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71288AB-A744-509E-8236-77D84A0AF0DD}"/>
              </a:ext>
            </a:extLst>
          </p:cNvPr>
          <p:cNvSpPr txBox="1"/>
          <p:nvPr/>
        </p:nvSpPr>
        <p:spPr>
          <a:xfrm>
            <a:off x="5619967" y="819805"/>
            <a:ext cx="12971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40ABA1E0-B16B-8912-650A-4367535631ED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57D86013-F397-524D-620F-0E7B696218EB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41D2E310-9A00-FCC6-652D-38687C02FFD8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6CE700A3-1A39-8DE0-0BAA-C17DAF07A23A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A67D240E-9923-8B46-F9E5-F01F77D30564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7AAA11FB-96E3-6378-B32F-2B206D967736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B6B5D2CA-BFBB-AC8D-258C-03C31924ECDC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36" name="直线连接符 35">
            <a:extLst>
              <a:ext uri="{FF2B5EF4-FFF2-40B4-BE49-F238E27FC236}">
                <a16:creationId xmlns:a16="http://schemas.microsoft.com/office/drawing/2014/main" id="{41476E40-0847-6065-A5D6-A78E5C5E2C52}"/>
              </a:ext>
            </a:extLst>
          </p:cNvPr>
          <p:cNvCxnSpPr>
            <a:cxnSpLocks/>
          </p:cNvCxnSpPr>
          <p:nvPr/>
        </p:nvCxnSpPr>
        <p:spPr>
          <a:xfrm>
            <a:off x="2146448" y="2521267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E2BE837F-8FD2-31F1-7AB3-0117F2DA4829}"/>
              </a:ext>
            </a:extLst>
          </p:cNvPr>
          <p:cNvSpPr txBox="1"/>
          <p:nvPr/>
        </p:nvSpPr>
        <p:spPr>
          <a:xfrm>
            <a:off x="1685987" y="2357459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700E1768-5A71-5164-A784-9EB231CE7D12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264476" y="2475030"/>
            <a:ext cx="2713924" cy="10125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90336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92C53A4-7C82-31D2-88C3-4873CCC7D39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 descr="电子设备&#10;&#10;AI 生成的内容可能不正确。">
            <a:extLst>
              <a:ext uri="{FF2B5EF4-FFF2-40B4-BE49-F238E27FC236}">
                <a16:creationId xmlns:a16="http://schemas.microsoft.com/office/drawing/2014/main" id="{5F30D159-61B7-4970-6A05-A6E428B95C35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301070" y="1769402"/>
            <a:ext cx="3806857" cy="2347424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F25C93BC-FE4A-52F0-46D1-0A4BC67F7AC6}"/>
              </a:ext>
            </a:extLst>
          </p:cNvPr>
          <p:cNvGrpSpPr>
            <a:grpSpLocks noChangeAspect="1"/>
          </p:cNvGrpSpPr>
          <p:nvPr/>
        </p:nvGrpSpPr>
        <p:grpSpPr>
          <a:xfrm>
            <a:off x="6961582" y="1922646"/>
            <a:ext cx="4327848" cy="1417913"/>
            <a:chOff x="8130365" y="3008119"/>
            <a:chExt cx="2382515" cy="780572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EF9416A7-CC2D-7E2A-5790-12DDA21A1758}"/>
                </a:ext>
              </a:extLst>
            </p:cNvPr>
            <p:cNvSpPr txBox="1"/>
            <p:nvPr/>
          </p:nvSpPr>
          <p:spPr>
            <a:xfrm>
              <a:off x="8130365" y="3555233"/>
              <a:ext cx="400816" cy="220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SHH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61715A52-C1ED-C04F-7A3F-B85AF88F6ED0}"/>
                </a:ext>
              </a:extLst>
            </p:cNvPr>
            <p:cNvSpPr txBox="1"/>
            <p:nvPr/>
          </p:nvSpPr>
          <p:spPr>
            <a:xfrm>
              <a:off x="10042349" y="3568427"/>
              <a:ext cx="470531" cy="220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D27E1DEA-ECA0-E825-DAD1-2D8A4602ACB5}"/>
                </a:ext>
              </a:extLst>
            </p:cNvPr>
            <p:cNvGrpSpPr/>
            <p:nvPr/>
          </p:nvGrpSpPr>
          <p:grpSpPr>
            <a:xfrm>
              <a:off x="8821212" y="3008119"/>
              <a:ext cx="1056183" cy="220267"/>
              <a:chOff x="3951176" y="3233578"/>
              <a:chExt cx="1056183" cy="220267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152F9367-61C1-B739-CD44-BFD521F53B4B}"/>
                  </a:ext>
                </a:extLst>
              </p:cNvPr>
              <p:cNvSpPr txBox="1"/>
              <p:nvPr/>
            </p:nvSpPr>
            <p:spPr>
              <a:xfrm>
                <a:off x="3951176" y="3233578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A2E6E215-96AF-34E4-36BD-D120F13302B7}"/>
                  </a:ext>
                </a:extLst>
              </p:cNvPr>
              <p:cNvSpPr txBox="1"/>
              <p:nvPr/>
            </p:nvSpPr>
            <p:spPr>
              <a:xfrm>
                <a:off x="4258075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689F31EF-B5E3-8EA0-AC05-08AB0A163258}"/>
                  </a:ext>
                </a:extLst>
              </p:cNvPr>
              <p:cNvSpPr txBox="1"/>
              <p:nvPr/>
            </p:nvSpPr>
            <p:spPr>
              <a:xfrm>
                <a:off x="4538947" y="3233581"/>
                <a:ext cx="180200" cy="220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E535D2DC-0948-7771-C509-EB2A416C61CB}"/>
                  </a:ext>
                </a:extLst>
              </p:cNvPr>
              <p:cNvSpPr txBox="1"/>
              <p:nvPr/>
            </p:nvSpPr>
            <p:spPr>
              <a:xfrm>
                <a:off x="4827159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8F7753E1-76E3-7FD3-C882-83F2253A4D3D}"/>
              </a:ext>
            </a:extLst>
          </p:cNvPr>
          <p:cNvSpPr txBox="1"/>
          <p:nvPr/>
        </p:nvSpPr>
        <p:spPr>
          <a:xfrm>
            <a:off x="1270420" y="2704193"/>
            <a:ext cx="72808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HH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48D3992-A41C-78D0-3F5C-C7C4AC154074}"/>
              </a:ext>
            </a:extLst>
          </p:cNvPr>
          <p:cNvSpPr txBox="1"/>
          <p:nvPr/>
        </p:nvSpPr>
        <p:spPr>
          <a:xfrm>
            <a:off x="2151170" y="3271758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线连接符 13">
            <a:extLst>
              <a:ext uri="{FF2B5EF4-FFF2-40B4-BE49-F238E27FC236}">
                <a16:creationId xmlns:a16="http://schemas.microsoft.com/office/drawing/2014/main" id="{6B2D7D55-A3B0-E9D2-CA7F-836DCCD0D35B}"/>
              </a:ext>
            </a:extLst>
          </p:cNvPr>
          <p:cNvCxnSpPr>
            <a:cxnSpLocks/>
          </p:cNvCxnSpPr>
          <p:nvPr/>
        </p:nvCxnSpPr>
        <p:spPr>
          <a:xfrm>
            <a:off x="2530713" y="3440806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2D7649A8-87E5-D0A8-F5B0-3024F9B8782F}"/>
              </a:ext>
            </a:extLst>
          </p:cNvPr>
          <p:cNvCxnSpPr>
            <a:cxnSpLocks/>
          </p:cNvCxnSpPr>
          <p:nvPr/>
        </p:nvCxnSpPr>
        <p:spPr>
          <a:xfrm>
            <a:off x="2530713" y="3216571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4C9C5BFD-2238-634E-864A-2FA8CE0D92A2}"/>
              </a:ext>
            </a:extLst>
          </p:cNvPr>
          <p:cNvSpPr txBox="1"/>
          <p:nvPr/>
        </p:nvSpPr>
        <p:spPr>
          <a:xfrm>
            <a:off x="2151170" y="3052619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08F766B-EFEE-7670-A086-D934F26BE31A}"/>
              </a:ext>
            </a:extLst>
          </p:cNvPr>
          <p:cNvSpPr txBox="1"/>
          <p:nvPr/>
        </p:nvSpPr>
        <p:spPr>
          <a:xfrm>
            <a:off x="5436306" y="2704193"/>
            <a:ext cx="8547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4825A96F-ADE8-CF0B-9C61-4FDB23499877}"/>
              </a:ext>
            </a:extLst>
          </p:cNvPr>
          <p:cNvGrpSpPr/>
          <p:nvPr/>
        </p:nvGrpSpPr>
        <p:grpSpPr>
          <a:xfrm>
            <a:off x="3060700" y="2038891"/>
            <a:ext cx="2147732" cy="434256"/>
            <a:chOff x="3965831" y="3305229"/>
            <a:chExt cx="1033486" cy="226766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634265A-3970-F74C-E4BB-DDF4B4521772}"/>
                </a:ext>
              </a:extLst>
            </p:cNvPr>
            <p:cNvSpPr txBox="1"/>
            <p:nvPr/>
          </p:nvSpPr>
          <p:spPr>
            <a:xfrm>
              <a:off x="3965831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CAC4D1EC-2B7D-C9DB-E350-867AE2FF658F}"/>
                </a:ext>
              </a:extLst>
            </p:cNvPr>
            <p:cNvSpPr txBox="1"/>
            <p:nvPr/>
          </p:nvSpPr>
          <p:spPr>
            <a:xfrm>
              <a:off x="42727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41ADB61-37F0-BA34-DE4E-031870CB779B}"/>
                </a:ext>
              </a:extLst>
            </p:cNvPr>
            <p:cNvSpPr txBox="1"/>
            <p:nvPr/>
          </p:nvSpPr>
          <p:spPr>
            <a:xfrm>
              <a:off x="4553599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5C1C7477-FC57-97BA-6440-71A7993F1012}"/>
                </a:ext>
              </a:extLst>
            </p:cNvPr>
            <p:cNvSpPr txBox="1"/>
            <p:nvPr/>
          </p:nvSpPr>
          <p:spPr>
            <a:xfrm>
              <a:off x="4841804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" name="直线连接符 5">
            <a:extLst>
              <a:ext uri="{FF2B5EF4-FFF2-40B4-BE49-F238E27FC236}">
                <a16:creationId xmlns:a16="http://schemas.microsoft.com/office/drawing/2014/main" id="{EF33D278-B552-5FB7-9820-D5AB86B5FD91}"/>
              </a:ext>
            </a:extLst>
          </p:cNvPr>
          <p:cNvCxnSpPr>
            <a:cxnSpLocks/>
          </p:cNvCxnSpPr>
          <p:nvPr/>
        </p:nvCxnSpPr>
        <p:spPr>
          <a:xfrm>
            <a:off x="2530713" y="2961676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7CBF6165-FE46-7C2B-1F61-E4E5911FDC29}"/>
              </a:ext>
            </a:extLst>
          </p:cNvPr>
          <p:cNvSpPr txBox="1"/>
          <p:nvPr/>
        </p:nvSpPr>
        <p:spPr>
          <a:xfrm>
            <a:off x="2151170" y="2799331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9D11E7E-0837-5DEC-39DC-82CA6FD31E29}"/>
              </a:ext>
            </a:extLst>
          </p:cNvPr>
          <p:cNvSpPr txBox="1"/>
          <p:nvPr/>
        </p:nvSpPr>
        <p:spPr>
          <a:xfrm>
            <a:off x="5619967" y="819805"/>
            <a:ext cx="142539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3803F934-76EB-E1FF-3A5A-8C56CBC6C609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63324DD8-9440-2458-F94A-B734C587B885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34C5BDD3-4EEF-804E-B08D-7AEA28C1E2E9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B48B19E8-B482-D5F8-81A6-99A31FBE396E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8FFE8593-9B4C-B450-3D14-5A1F5B3C3FCF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AE4CA3DF-9508-8F68-DC01-AE8599270C31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BD8C0120-369D-11B7-BD65-70AECAF263D9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36" name="直线连接符 35">
            <a:extLst>
              <a:ext uri="{FF2B5EF4-FFF2-40B4-BE49-F238E27FC236}">
                <a16:creationId xmlns:a16="http://schemas.microsoft.com/office/drawing/2014/main" id="{312507CE-975F-BE9E-AD18-DAC08F307CEC}"/>
              </a:ext>
            </a:extLst>
          </p:cNvPr>
          <p:cNvCxnSpPr>
            <a:cxnSpLocks/>
          </p:cNvCxnSpPr>
          <p:nvPr/>
        </p:nvCxnSpPr>
        <p:spPr>
          <a:xfrm>
            <a:off x="2530713" y="2582264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6AFBDD7A-67CC-8F7B-4DD4-4E303C00BB1A}"/>
              </a:ext>
            </a:extLst>
          </p:cNvPr>
          <p:cNvSpPr txBox="1"/>
          <p:nvPr/>
        </p:nvSpPr>
        <p:spPr>
          <a:xfrm>
            <a:off x="2058807" y="2418456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989CAB69-3334-4E77-A411-ED95E3B87B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640753" y="2486871"/>
            <a:ext cx="2768443" cy="9889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37784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9D473B8-4EBE-720F-A3F9-A37C710690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图片 34">
            <a:extLst>
              <a:ext uri="{FF2B5EF4-FFF2-40B4-BE49-F238E27FC236}">
                <a16:creationId xmlns:a16="http://schemas.microsoft.com/office/drawing/2014/main" id="{6DFBED25-5DF2-9C8F-61FD-191259BCB3D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256065" y="2215231"/>
            <a:ext cx="3021745" cy="1664036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4408CC6-C6AF-BC97-25EA-8DAB65523E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620511" y="1716961"/>
            <a:ext cx="3908261" cy="2881065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8BCAACAB-F362-EDA8-1390-D3F311D95014}"/>
              </a:ext>
            </a:extLst>
          </p:cNvPr>
          <p:cNvGrpSpPr>
            <a:grpSpLocks noChangeAspect="1"/>
          </p:cNvGrpSpPr>
          <p:nvPr/>
        </p:nvGrpSpPr>
        <p:grpSpPr>
          <a:xfrm>
            <a:off x="7051311" y="1753318"/>
            <a:ext cx="4540523" cy="1430975"/>
            <a:chOff x="8179755" y="3008119"/>
            <a:chExt cx="2499593" cy="787762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02DC6B83-5A34-2571-4FA1-0E333632469E}"/>
                </a:ext>
              </a:extLst>
            </p:cNvPr>
            <p:cNvSpPr txBox="1"/>
            <p:nvPr/>
          </p:nvSpPr>
          <p:spPr>
            <a:xfrm>
              <a:off x="8179755" y="3562422"/>
              <a:ext cx="422877" cy="2202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SMO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90F87F9D-8594-5966-0E84-E51B3869576C}"/>
                </a:ext>
              </a:extLst>
            </p:cNvPr>
            <p:cNvSpPr txBox="1"/>
            <p:nvPr/>
          </p:nvSpPr>
          <p:spPr>
            <a:xfrm>
              <a:off x="10208818" y="3575618"/>
              <a:ext cx="470530" cy="2202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86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AF403B9A-F3F5-EC34-2130-D1087706B4C0}"/>
                </a:ext>
              </a:extLst>
            </p:cNvPr>
            <p:cNvGrpSpPr/>
            <p:nvPr/>
          </p:nvGrpSpPr>
          <p:grpSpPr>
            <a:xfrm>
              <a:off x="8789749" y="3008119"/>
              <a:ext cx="1056184" cy="220267"/>
              <a:chOff x="3919713" y="3233578"/>
              <a:chExt cx="1056184" cy="220267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B154CD1A-B5CF-3B3F-5F77-084F50E78580}"/>
                  </a:ext>
                </a:extLst>
              </p:cNvPr>
              <p:cNvSpPr txBox="1"/>
              <p:nvPr/>
            </p:nvSpPr>
            <p:spPr>
              <a:xfrm>
                <a:off x="3919713" y="3233578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08BB0830-6324-17C5-FAD7-8B2D90F1A33A}"/>
                  </a:ext>
                </a:extLst>
              </p:cNvPr>
              <p:cNvSpPr txBox="1"/>
              <p:nvPr/>
            </p:nvSpPr>
            <p:spPr>
              <a:xfrm>
                <a:off x="4226614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B1D5D497-C6E3-CFC1-6E10-E69B80E6BE7A}"/>
                  </a:ext>
                </a:extLst>
              </p:cNvPr>
              <p:cNvSpPr txBox="1"/>
              <p:nvPr/>
            </p:nvSpPr>
            <p:spPr>
              <a:xfrm>
                <a:off x="4507484" y="3233581"/>
                <a:ext cx="180200" cy="220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FEE10348-8E67-2A8F-CF87-EEA495A0BDF5}"/>
                  </a:ext>
                </a:extLst>
              </p:cNvPr>
              <p:cNvSpPr txBox="1"/>
              <p:nvPr/>
            </p:nvSpPr>
            <p:spPr>
              <a:xfrm>
                <a:off x="4795697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974B1125-E615-9D12-DE38-D90DCECA8F35}"/>
              </a:ext>
            </a:extLst>
          </p:cNvPr>
          <p:cNvSpPr txBox="1"/>
          <p:nvPr/>
        </p:nvSpPr>
        <p:spPr>
          <a:xfrm>
            <a:off x="770038" y="2757385"/>
            <a:ext cx="768159" cy="400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MO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50E819B-556B-0375-9480-7EA521271141}"/>
              </a:ext>
            </a:extLst>
          </p:cNvPr>
          <p:cNvSpPr txBox="1"/>
          <p:nvPr/>
        </p:nvSpPr>
        <p:spPr>
          <a:xfrm>
            <a:off x="1728804" y="3014881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线连接符 13">
            <a:extLst>
              <a:ext uri="{FF2B5EF4-FFF2-40B4-BE49-F238E27FC236}">
                <a16:creationId xmlns:a16="http://schemas.microsoft.com/office/drawing/2014/main" id="{F469F2F6-CA17-F463-8932-7AC0B6E0D81D}"/>
              </a:ext>
            </a:extLst>
          </p:cNvPr>
          <p:cNvCxnSpPr>
            <a:cxnSpLocks/>
          </p:cNvCxnSpPr>
          <p:nvPr/>
        </p:nvCxnSpPr>
        <p:spPr>
          <a:xfrm>
            <a:off x="2146448" y="3183929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A55A43C4-8713-CF7F-16B0-0523F627278C}"/>
              </a:ext>
            </a:extLst>
          </p:cNvPr>
          <p:cNvCxnSpPr>
            <a:cxnSpLocks/>
          </p:cNvCxnSpPr>
          <p:nvPr/>
        </p:nvCxnSpPr>
        <p:spPr>
          <a:xfrm>
            <a:off x="2146448" y="2940856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24B242D5-E1DC-154E-DFB9-434978E57B9D}"/>
              </a:ext>
            </a:extLst>
          </p:cNvPr>
          <p:cNvSpPr txBox="1"/>
          <p:nvPr/>
        </p:nvSpPr>
        <p:spPr>
          <a:xfrm>
            <a:off x="1636441" y="2776904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D3BD209-3F0C-13D1-A278-7AED65D8679A}"/>
              </a:ext>
            </a:extLst>
          </p:cNvPr>
          <p:cNvSpPr txBox="1"/>
          <p:nvPr/>
        </p:nvSpPr>
        <p:spPr>
          <a:xfrm>
            <a:off x="5340877" y="2757385"/>
            <a:ext cx="8547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86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78E2F761-DE5D-DE5F-17E4-4251D8BC3ECB}"/>
              </a:ext>
            </a:extLst>
          </p:cNvPr>
          <p:cNvGrpSpPr/>
          <p:nvPr/>
        </p:nvGrpSpPr>
        <p:grpSpPr>
          <a:xfrm>
            <a:off x="2743200" y="1746580"/>
            <a:ext cx="2147732" cy="434256"/>
            <a:chOff x="3965831" y="3305229"/>
            <a:chExt cx="1033486" cy="226766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3371D411-1EB6-8ED8-564C-B5FD14F808A5}"/>
                </a:ext>
              </a:extLst>
            </p:cNvPr>
            <p:cNvSpPr txBox="1"/>
            <p:nvPr/>
          </p:nvSpPr>
          <p:spPr>
            <a:xfrm>
              <a:off x="3965831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B908ECF9-4C2D-F7B5-5DD2-0AC094B67D67}"/>
                </a:ext>
              </a:extLst>
            </p:cNvPr>
            <p:cNvSpPr txBox="1"/>
            <p:nvPr/>
          </p:nvSpPr>
          <p:spPr>
            <a:xfrm>
              <a:off x="42727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F4B4B9E6-33B7-59A6-B1A4-ED54C1653293}"/>
                </a:ext>
              </a:extLst>
            </p:cNvPr>
            <p:cNvSpPr txBox="1"/>
            <p:nvPr/>
          </p:nvSpPr>
          <p:spPr>
            <a:xfrm>
              <a:off x="4553599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F66D06AF-4EE6-1C0D-1D6E-A3588EFBB0C7}"/>
                </a:ext>
              </a:extLst>
            </p:cNvPr>
            <p:cNvSpPr txBox="1"/>
            <p:nvPr/>
          </p:nvSpPr>
          <p:spPr>
            <a:xfrm>
              <a:off x="4841804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" name="直线连接符 5">
            <a:extLst>
              <a:ext uri="{FF2B5EF4-FFF2-40B4-BE49-F238E27FC236}">
                <a16:creationId xmlns:a16="http://schemas.microsoft.com/office/drawing/2014/main" id="{FDA192FA-DC41-A9D0-3B25-B39E373A4EA9}"/>
              </a:ext>
            </a:extLst>
          </p:cNvPr>
          <p:cNvCxnSpPr>
            <a:cxnSpLocks/>
          </p:cNvCxnSpPr>
          <p:nvPr/>
        </p:nvCxnSpPr>
        <p:spPr>
          <a:xfrm>
            <a:off x="2146448" y="2642517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34D403EB-04B6-BAD5-8C10-915735E53E5A}"/>
              </a:ext>
            </a:extLst>
          </p:cNvPr>
          <p:cNvSpPr txBox="1"/>
          <p:nvPr/>
        </p:nvSpPr>
        <p:spPr>
          <a:xfrm>
            <a:off x="1636441" y="2480172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0E3717C0-5E17-6FC9-1F35-9E140E2FB061}"/>
              </a:ext>
            </a:extLst>
          </p:cNvPr>
          <p:cNvSpPr txBox="1"/>
          <p:nvPr/>
        </p:nvSpPr>
        <p:spPr>
          <a:xfrm>
            <a:off x="5619967" y="819805"/>
            <a:ext cx="12971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4BFC7430-8D70-73EA-6783-80E7AD771FAA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699D9DC9-BB75-A2EA-2126-F46A4F9EF460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66F2DCBE-DF09-30CE-4EC1-EFB88363C6D5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DBE0EBAF-E6B1-6E04-451B-72CEC87BB530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59CAAC4F-9F1F-6EE3-E2B4-382FCE7F5D73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48BFE059-5E70-642B-4C17-BB05A563BADB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E88C1759-0B54-59F5-0ED1-DCC5A3460A26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36" name="直线连接符 35">
            <a:extLst>
              <a:ext uri="{FF2B5EF4-FFF2-40B4-BE49-F238E27FC236}">
                <a16:creationId xmlns:a16="http://schemas.microsoft.com/office/drawing/2014/main" id="{B6B9DCC4-9E49-DE1D-1992-C1A70881D21B}"/>
              </a:ext>
            </a:extLst>
          </p:cNvPr>
          <p:cNvCxnSpPr>
            <a:cxnSpLocks/>
          </p:cNvCxnSpPr>
          <p:nvPr/>
        </p:nvCxnSpPr>
        <p:spPr>
          <a:xfrm>
            <a:off x="2146448" y="2388518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B5C1502D-A70F-1101-5DEB-8F6414DDDC98}"/>
              </a:ext>
            </a:extLst>
          </p:cNvPr>
          <p:cNvSpPr txBox="1"/>
          <p:nvPr/>
        </p:nvSpPr>
        <p:spPr>
          <a:xfrm>
            <a:off x="1636441" y="2224710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线连接符 37">
            <a:extLst>
              <a:ext uri="{FF2B5EF4-FFF2-40B4-BE49-F238E27FC236}">
                <a16:creationId xmlns:a16="http://schemas.microsoft.com/office/drawing/2014/main" id="{AEDD31F2-0D9A-C04C-0E55-64338C5794EE}"/>
              </a:ext>
            </a:extLst>
          </p:cNvPr>
          <p:cNvCxnSpPr>
            <a:cxnSpLocks/>
          </p:cNvCxnSpPr>
          <p:nvPr/>
        </p:nvCxnSpPr>
        <p:spPr>
          <a:xfrm>
            <a:off x="2146448" y="3622653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07498C5B-4BF4-39EA-5922-5004E63264DE}"/>
              </a:ext>
            </a:extLst>
          </p:cNvPr>
          <p:cNvSpPr txBox="1"/>
          <p:nvPr/>
        </p:nvSpPr>
        <p:spPr>
          <a:xfrm>
            <a:off x="1728804" y="3455862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051207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47A9386-64BE-DA89-3B37-AA685E3C83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图片 25">
            <a:extLst>
              <a:ext uri="{FF2B5EF4-FFF2-40B4-BE49-F238E27FC236}">
                <a16:creationId xmlns:a16="http://schemas.microsoft.com/office/drawing/2014/main" id="{ED752307-2794-2361-AD48-DF2F943747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320353" y="2185452"/>
            <a:ext cx="2719691" cy="1506067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AFFEFEE8-8D40-B6D9-EFCA-997E2BF8B3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204005" y="1466494"/>
            <a:ext cx="4148573" cy="3267149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34B076A5-0D71-5B9E-B911-836FC7CE30C5}"/>
              </a:ext>
            </a:extLst>
          </p:cNvPr>
          <p:cNvGrpSpPr>
            <a:grpSpLocks noChangeAspect="1"/>
          </p:cNvGrpSpPr>
          <p:nvPr/>
        </p:nvGrpSpPr>
        <p:grpSpPr>
          <a:xfrm>
            <a:off x="6704139" y="1753312"/>
            <a:ext cx="4585297" cy="1417911"/>
            <a:chOff x="7988637" y="3008119"/>
            <a:chExt cx="2524242" cy="780571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DF8A9694-A8E6-DF1B-E6BF-D3C558DB1C3E}"/>
                </a:ext>
              </a:extLst>
            </p:cNvPr>
            <p:cNvSpPr txBox="1"/>
            <p:nvPr/>
          </p:nvSpPr>
          <p:spPr>
            <a:xfrm>
              <a:off x="7988637" y="3555233"/>
              <a:ext cx="422877" cy="2202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SMO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E474D1EE-3D98-A9C9-6EA8-3F80595A71BA}"/>
                </a:ext>
              </a:extLst>
            </p:cNvPr>
            <p:cNvSpPr txBox="1"/>
            <p:nvPr/>
          </p:nvSpPr>
          <p:spPr>
            <a:xfrm>
              <a:off x="10042349" y="3568427"/>
              <a:ext cx="470530" cy="2202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86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0E60C042-A43E-716E-5DA2-9206CDE383B6}"/>
                </a:ext>
              </a:extLst>
            </p:cNvPr>
            <p:cNvGrpSpPr/>
            <p:nvPr/>
          </p:nvGrpSpPr>
          <p:grpSpPr>
            <a:xfrm>
              <a:off x="8821212" y="3008119"/>
              <a:ext cx="1056183" cy="220267"/>
              <a:chOff x="3951176" y="3233578"/>
              <a:chExt cx="1056183" cy="220267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FDF5631D-A9E8-AFAB-C5BA-B3C55E43D4D8}"/>
                  </a:ext>
                </a:extLst>
              </p:cNvPr>
              <p:cNvSpPr txBox="1"/>
              <p:nvPr/>
            </p:nvSpPr>
            <p:spPr>
              <a:xfrm>
                <a:off x="3951176" y="3233578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44BB45CE-33EB-6414-E3F4-DCB9227232D7}"/>
                  </a:ext>
                </a:extLst>
              </p:cNvPr>
              <p:cNvSpPr txBox="1"/>
              <p:nvPr/>
            </p:nvSpPr>
            <p:spPr>
              <a:xfrm>
                <a:off x="4258075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587808B6-3BB4-BA1A-8DB3-72E9DA8BC9A4}"/>
                  </a:ext>
                </a:extLst>
              </p:cNvPr>
              <p:cNvSpPr txBox="1"/>
              <p:nvPr/>
            </p:nvSpPr>
            <p:spPr>
              <a:xfrm>
                <a:off x="4538947" y="3233581"/>
                <a:ext cx="180200" cy="220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6999E5CE-560F-8D43-B5C2-67632C5A32C1}"/>
                  </a:ext>
                </a:extLst>
              </p:cNvPr>
              <p:cNvSpPr txBox="1"/>
              <p:nvPr/>
            </p:nvSpPr>
            <p:spPr>
              <a:xfrm>
                <a:off x="4827159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978DCA28-BFF3-BA67-B5A1-E4DD040112C4}"/>
              </a:ext>
            </a:extLst>
          </p:cNvPr>
          <p:cNvSpPr txBox="1"/>
          <p:nvPr/>
        </p:nvSpPr>
        <p:spPr>
          <a:xfrm>
            <a:off x="952920" y="2652881"/>
            <a:ext cx="768159" cy="400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MO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D029C07-93BF-2F9C-8C93-A0E4477B5568}"/>
              </a:ext>
            </a:extLst>
          </p:cNvPr>
          <p:cNvSpPr txBox="1"/>
          <p:nvPr/>
        </p:nvSpPr>
        <p:spPr>
          <a:xfrm>
            <a:off x="1795170" y="2889521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线连接符 13">
            <a:extLst>
              <a:ext uri="{FF2B5EF4-FFF2-40B4-BE49-F238E27FC236}">
                <a16:creationId xmlns:a16="http://schemas.microsoft.com/office/drawing/2014/main" id="{7C9AC92E-1D92-6279-A40C-5B5259B2CD74}"/>
              </a:ext>
            </a:extLst>
          </p:cNvPr>
          <p:cNvCxnSpPr>
            <a:cxnSpLocks/>
          </p:cNvCxnSpPr>
          <p:nvPr/>
        </p:nvCxnSpPr>
        <p:spPr>
          <a:xfrm>
            <a:off x="2212814" y="3058569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1D334694-1171-B50A-D693-DD1373E1FF69}"/>
              </a:ext>
            </a:extLst>
          </p:cNvPr>
          <p:cNvCxnSpPr>
            <a:cxnSpLocks/>
          </p:cNvCxnSpPr>
          <p:nvPr/>
        </p:nvCxnSpPr>
        <p:spPr>
          <a:xfrm>
            <a:off x="2212814" y="2831729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643BC1D7-3643-226C-FE54-646DE4E8F039}"/>
              </a:ext>
            </a:extLst>
          </p:cNvPr>
          <p:cNvSpPr txBox="1"/>
          <p:nvPr/>
        </p:nvSpPr>
        <p:spPr>
          <a:xfrm>
            <a:off x="1702807" y="2667777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F07F1AC-6E25-E245-39E4-BA7A1FBA6FF5}"/>
              </a:ext>
            </a:extLst>
          </p:cNvPr>
          <p:cNvSpPr txBox="1"/>
          <p:nvPr/>
        </p:nvSpPr>
        <p:spPr>
          <a:xfrm>
            <a:off x="5118806" y="2652881"/>
            <a:ext cx="8547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86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32132F33-0C12-E8BD-1488-20BE59E14920}"/>
              </a:ext>
            </a:extLst>
          </p:cNvPr>
          <p:cNvGrpSpPr/>
          <p:nvPr/>
        </p:nvGrpSpPr>
        <p:grpSpPr>
          <a:xfrm>
            <a:off x="2743200" y="1746580"/>
            <a:ext cx="2147732" cy="434256"/>
            <a:chOff x="3965831" y="3305229"/>
            <a:chExt cx="1033486" cy="226766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F62E35C-DEC3-CC6A-403B-772A6EF51F78}"/>
                </a:ext>
              </a:extLst>
            </p:cNvPr>
            <p:cNvSpPr txBox="1"/>
            <p:nvPr/>
          </p:nvSpPr>
          <p:spPr>
            <a:xfrm>
              <a:off x="3965831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67DFFE02-A965-E188-AC94-685EE2A619DE}"/>
                </a:ext>
              </a:extLst>
            </p:cNvPr>
            <p:cNvSpPr txBox="1"/>
            <p:nvPr/>
          </p:nvSpPr>
          <p:spPr>
            <a:xfrm>
              <a:off x="42727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C8112BC-27CF-F165-ADDB-ED769FD5989D}"/>
                </a:ext>
              </a:extLst>
            </p:cNvPr>
            <p:cNvSpPr txBox="1"/>
            <p:nvPr/>
          </p:nvSpPr>
          <p:spPr>
            <a:xfrm>
              <a:off x="4553599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A29FEF71-31FD-0D67-848A-0312E8267BE8}"/>
                </a:ext>
              </a:extLst>
            </p:cNvPr>
            <p:cNvSpPr txBox="1"/>
            <p:nvPr/>
          </p:nvSpPr>
          <p:spPr>
            <a:xfrm>
              <a:off x="4841804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" name="直线连接符 5">
            <a:extLst>
              <a:ext uri="{FF2B5EF4-FFF2-40B4-BE49-F238E27FC236}">
                <a16:creationId xmlns:a16="http://schemas.microsoft.com/office/drawing/2014/main" id="{4F1B5869-220D-95A9-2B77-DE239E7BC50F}"/>
              </a:ext>
            </a:extLst>
          </p:cNvPr>
          <p:cNvCxnSpPr>
            <a:cxnSpLocks/>
          </p:cNvCxnSpPr>
          <p:nvPr/>
        </p:nvCxnSpPr>
        <p:spPr>
          <a:xfrm>
            <a:off x="2212814" y="2549623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5A4D4012-120A-A0EA-0D1A-473A40E65503}"/>
              </a:ext>
            </a:extLst>
          </p:cNvPr>
          <p:cNvSpPr txBox="1"/>
          <p:nvPr/>
        </p:nvSpPr>
        <p:spPr>
          <a:xfrm>
            <a:off x="1702807" y="2387278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2955835E-8A6D-582C-B2A7-E9CE0A6F0AEC}"/>
              </a:ext>
            </a:extLst>
          </p:cNvPr>
          <p:cNvSpPr txBox="1"/>
          <p:nvPr/>
        </p:nvSpPr>
        <p:spPr>
          <a:xfrm>
            <a:off x="5619967" y="819805"/>
            <a:ext cx="142539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SNU-C1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0F1045AC-72EB-3232-9F5A-70BF1276636D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055FA676-46A6-6D60-23E2-D8ED45AAE03F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BFBEBF76-CFD8-86CF-91AD-C9D140343EC9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2B187BCE-C4C4-F653-A266-2322A107127F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6EEC137E-7A9F-0D58-9E15-E96F6022B655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34E044B6-C8D0-3581-696C-C6DAF69C1B74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8C29C7FD-37F1-027B-FDFC-B9D79E6982A0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36" name="直线连接符 35">
            <a:extLst>
              <a:ext uri="{FF2B5EF4-FFF2-40B4-BE49-F238E27FC236}">
                <a16:creationId xmlns:a16="http://schemas.microsoft.com/office/drawing/2014/main" id="{D38462B0-D8E1-8562-D181-13E386B7FEBD}"/>
              </a:ext>
            </a:extLst>
          </p:cNvPr>
          <p:cNvCxnSpPr>
            <a:cxnSpLocks/>
          </p:cNvCxnSpPr>
          <p:nvPr/>
        </p:nvCxnSpPr>
        <p:spPr>
          <a:xfrm>
            <a:off x="2212814" y="2333497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0DDB0B5E-C330-7EFA-8213-550B1047F3DD}"/>
              </a:ext>
            </a:extLst>
          </p:cNvPr>
          <p:cNvSpPr txBox="1"/>
          <p:nvPr/>
        </p:nvSpPr>
        <p:spPr>
          <a:xfrm>
            <a:off x="1702807" y="2169689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线连接符 37">
            <a:extLst>
              <a:ext uri="{FF2B5EF4-FFF2-40B4-BE49-F238E27FC236}">
                <a16:creationId xmlns:a16="http://schemas.microsoft.com/office/drawing/2014/main" id="{CE67EC10-9AA3-0F89-FF6B-44882E94BE1A}"/>
              </a:ext>
            </a:extLst>
          </p:cNvPr>
          <p:cNvCxnSpPr>
            <a:cxnSpLocks/>
          </p:cNvCxnSpPr>
          <p:nvPr/>
        </p:nvCxnSpPr>
        <p:spPr>
          <a:xfrm>
            <a:off x="2212814" y="3443186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84D1879E-FF88-8B9B-54FD-1FA3A7628537}"/>
              </a:ext>
            </a:extLst>
          </p:cNvPr>
          <p:cNvSpPr txBox="1"/>
          <p:nvPr/>
        </p:nvSpPr>
        <p:spPr>
          <a:xfrm>
            <a:off x="1795170" y="3276395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67541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A56CB64-B573-59E9-75DD-6DC3EA059D0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32">
            <a:extLst>
              <a:ext uri="{FF2B5EF4-FFF2-40B4-BE49-F238E27FC236}">
                <a16:creationId xmlns:a16="http://schemas.microsoft.com/office/drawing/2014/main" id="{8931BBE0-A1B1-3F3C-B1FD-7D7734BCB8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178755" y="2316657"/>
            <a:ext cx="2892191" cy="139373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6DF3829-731E-C127-D84C-3330B020D31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7293316" y="2180835"/>
            <a:ext cx="3171406" cy="1548571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5068D120-9A09-DBB1-E578-B2B55E9EEC13}"/>
              </a:ext>
            </a:extLst>
          </p:cNvPr>
          <p:cNvGrpSpPr>
            <a:grpSpLocks noChangeAspect="1"/>
          </p:cNvGrpSpPr>
          <p:nvPr/>
        </p:nvGrpSpPr>
        <p:grpSpPr>
          <a:xfrm>
            <a:off x="6458286" y="1753309"/>
            <a:ext cx="4881368" cy="1274559"/>
            <a:chOff x="7853291" y="3008119"/>
            <a:chExt cx="2687231" cy="701655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A2AE1A81-32AA-827B-C3BF-9FD5688E0D3B}"/>
                </a:ext>
              </a:extLst>
            </p:cNvPr>
            <p:cNvSpPr txBox="1"/>
            <p:nvPr/>
          </p:nvSpPr>
          <p:spPr>
            <a:xfrm>
              <a:off x="7853291" y="3476317"/>
              <a:ext cx="543776" cy="220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l-GR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CB679147-0ED9-7A72-19F5-E54132993478}"/>
                </a:ext>
              </a:extLst>
            </p:cNvPr>
            <p:cNvSpPr txBox="1"/>
            <p:nvPr/>
          </p:nvSpPr>
          <p:spPr>
            <a:xfrm>
              <a:off x="10069991" y="3489510"/>
              <a:ext cx="470531" cy="2202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5</a:t>
              </a:r>
              <a:r>
                <a: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zh-CN" sz="2000" dirty="0" err="1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" name="组合 59">
              <a:extLst>
                <a:ext uri="{FF2B5EF4-FFF2-40B4-BE49-F238E27FC236}">
                  <a16:creationId xmlns:a16="http://schemas.microsoft.com/office/drawing/2014/main" id="{24DEE416-5827-2E70-1A13-2BE110D4FC68}"/>
                </a:ext>
              </a:extLst>
            </p:cNvPr>
            <p:cNvGrpSpPr/>
            <p:nvPr/>
          </p:nvGrpSpPr>
          <p:grpSpPr>
            <a:xfrm>
              <a:off x="8789749" y="3008119"/>
              <a:ext cx="1056184" cy="220267"/>
              <a:chOff x="3919713" y="3233578"/>
              <a:chExt cx="1056184" cy="220267"/>
            </a:xfrm>
          </p:grpSpPr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24C9301F-0F63-3A35-9E92-38D1D00263BE}"/>
                  </a:ext>
                </a:extLst>
              </p:cNvPr>
              <p:cNvSpPr txBox="1"/>
              <p:nvPr/>
            </p:nvSpPr>
            <p:spPr>
              <a:xfrm>
                <a:off x="3919713" y="3233578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A29C3732-D808-9293-21D3-7DD19071909B}"/>
                  </a:ext>
                </a:extLst>
              </p:cNvPr>
              <p:cNvSpPr txBox="1"/>
              <p:nvPr/>
            </p:nvSpPr>
            <p:spPr>
              <a:xfrm>
                <a:off x="4226614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6B9024AA-87BF-427F-EE04-9DB36E945579}"/>
                  </a:ext>
                </a:extLst>
              </p:cNvPr>
              <p:cNvSpPr txBox="1"/>
              <p:nvPr/>
            </p:nvSpPr>
            <p:spPr>
              <a:xfrm>
                <a:off x="4507484" y="3233581"/>
                <a:ext cx="180200" cy="22026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0ECD80ED-5C3C-8E83-F98D-F514B0EFF5D6}"/>
                  </a:ext>
                </a:extLst>
              </p:cNvPr>
              <p:cNvSpPr txBox="1"/>
              <p:nvPr/>
            </p:nvSpPr>
            <p:spPr>
              <a:xfrm>
                <a:off x="4795697" y="3233581"/>
                <a:ext cx="180200" cy="2202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3681CE36-BE72-6854-4B2D-8B6B3770B01E}"/>
              </a:ext>
            </a:extLst>
          </p:cNvPr>
          <p:cNvSpPr txBox="1"/>
          <p:nvPr/>
        </p:nvSpPr>
        <p:spPr>
          <a:xfrm>
            <a:off x="655896" y="2757385"/>
            <a:ext cx="987771" cy="400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l-GR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723875A-7DBC-2704-BC23-B0DA89B1BC2A}"/>
              </a:ext>
            </a:extLst>
          </p:cNvPr>
          <p:cNvSpPr txBox="1"/>
          <p:nvPr/>
        </p:nvSpPr>
        <p:spPr>
          <a:xfrm>
            <a:off x="1643545" y="3392703"/>
            <a:ext cx="446917" cy="3505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线连接符 13">
            <a:extLst>
              <a:ext uri="{FF2B5EF4-FFF2-40B4-BE49-F238E27FC236}">
                <a16:creationId xmlns:a16="http://schemas.microsoft.com/office/drawing/2014/main" id="{1D5D4081-1EE2-13C0-4284-AA5232638C42}"/>
              </a:ext>
            </a:extLst>
          </p:cNvPr>
          <p:cNvCxnSpPr>
            <a:cxnSpLocks/>
          </p:cNvCxnSpPr>
          <p:nvPr/>
        </p:nvCxnSpPr>
        <p:spPr>
          <a:xfrm>
            <a:off x="2061189" y="3580223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04DBAC63-0A33-2BC5-0A16-601F04E3D1DE}"/>
              </a:ext>
            </a:extLst>
          </p:cNvPr>
          <p:cNvCxnSpPr>
            <a:cxnSpLocks/>
          </p:cNvCxnSpPr>
          <p:nvPr/>
        </p:nvCxnSpPr>
        <p:spPr>
          <a:xfrm>
            <a:off x="2061189" y="3123639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CEE6A42A-7A6C-637B-B739-89A46EB255F8}"/>
              </a:ext>
            </a:extLst>
          </p:cNvPr>
          <p:cNvSpPr txBox="1"/>
          <p:nvPr/>
        </p:nvSpPr>
        <p:spPr>
          <a:xfrm>
            <a:off x="1643545" y="2946267"/>
            <a:ext cx="446917" cy="3505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3D8B9BB-891B-9AF7-E8BE-F38D1A08AF2B}"/>
              </a:ext>
            </a:extLst>
          </p:cNvPr>
          <p:cNvSpPr txBox="1"/>
          <p:nvPr/>
        </p:nvSpPr>
        <p:spPr>
          <a:xfrm>
            <a:off x="5081222" y="2746096"/>
            <a:ext cx="85472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r>
              <a: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endParaRPr kumimoji="1"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组合 20">
            <a:extLst>
              <a:ext uri="{FF2B5EF4-FFF2-40B4-BE49-F238E27FC236}">
                <a16:creationId xmlns:a16="http://schemas.microsoft.com/office/drawing/2014/main" id="{600FF92C-05FD-910A-B9DB-4454138C0EAA}"/>
              </a:ext>
            </a:extLst>
          </p:cNvPr>
          <p:cNvGrpSpPr/>
          <p:nvPr/>
        </p:nvGrpSpPr>
        <p:grpSpPr>
          <a:xfrm>
            <a:off x="2743195" y="1746580"/>
            <a:ext cx="2147732" cy="434256"/>
            <a:chOff x="3965831" y="3305229"/>
            <a:chExt cx="1033486" cy="226766"/>
          </a:xfrm>
        </p:grpSpPr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886861F9-E065-5EF4-3F29-545914296D86}"/>
                </a:ext>
              </a:extLst>
            </p:cNvPr>
            <p:cNvSpPr txBox="1"/>
            <p:nvPr/>
          </p:nvSpPr>
          <p:spPr>
            <a:xfrm>
              <a:off x="3965831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B9C2B414-EA55-8EEF-9406-ABA58C5570C1}"/>
                </a:ext>
              </a:extLst>
            </p:cNvPr>
            <p:cNvSpPr txBox="1"/>
            <p:nvPr/>
          </p:nvSpPr>
          <p:spPr>
            <a:xfrm>
              <a:off x="4272728" y="3305229"/>
              <a:ext cx="170955" cy="2267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0AF36235-5782-D271-D6A5-88CED61F68C4}"/>
                </a:ext>
              </a:extLst>
            </p:cNvPr>
            <p:cNvSpPr txBox="1"/>
            <p:nvPr/>
          </p:nvSpPr>
          <p:spPr>
            <a:xfrm>
              <a:off x="4553599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F74626CA-325B-0078-F172-117109FE4906}"/>
                </a:ext>
              </a:extLst>
            </p:cNvPr>
            <p:cNvSpPr txBox="1"/>
            <p:nvPr/>
          </p:nvSpPr>
          <p:spPr>
            <a:xfrm>
              <a:off x="4841804" y="3305229"/>
              <a:ext cx="157513" cy="20893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kumimoji="1"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6" name="直线连接符 5">
            <a:extLst>
              <a:ext uri="{FF2B5EF4-FFF2-40B4-BE49-F238E27FC236}">
                <a16:creationId xmlns:a16="http://schemas.microsoft.com/office/drawing/2014/main" id="{9E4530CE-FF8A-0FE4-8874-9B19A5307784}"/>
              </a:ext>
            </a:extLst>
          </p:cNvPr>
          <p:cNvCxnSpPr>
            <a:cxnSpLocks/>
          </p:cNvCxnSpPr>
          <p:nvPr/>
        </p:nvCxnSpPr>
        <p:spPr>
          <a:xfrm>
            <a:off x="2061189" y="2806111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FE5A19BD-5E13-3159-B0DD-DA83B21A9093}"/>
              </a:ext>
            </a:extLst>
          </p:cNvPr>
          <p:cNvSpPr txBox="1"/>
          <p:nvPr/>
        </p:nvSpPr>
        <p:spPr>
          <a:xfrm>
            <a:off x="1643545" y="2637490"/>
            <a:ext cx="446917" cy="3505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EDC13E8-651F-22F4-6070-219630168AA8}"/>
              </a:ext>
            </a:extLst>
          </p:cNvPr>
          <p:cNvSpPr txBox="1"/>
          <p:nvPr/>
        </p:nvSpPr>
        <p:spPr>
          <a:xfrm>
            <a:off x="5619967" y="819805"/>
            <a:ext cx="12971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2600" b="1" dirty="0">
                <a:latin typeface="Arial" panose="020B0604020202020204" pitchFamily="34" charset="0"/>
                <a:cs typeface="Arial" panose="020B0604020202020204" pitchFamily="34" charset="0"/>
              </a:rPr>
              <a:t>CaCO2</a:t>
            </a:r>
            <a:endParaRPr kumimoji="1" lang="zh-CN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DB418EB5-AE76-9530-8974-127259E553BA}"/>
              </a:ext>
            </a:extLst>
          </p:cNvPr>
          <p:cNvGrpSpPr/>
          <p:nvPr/>
        </p:nvGrpSpPr>
        <p:grpSpPr>
          <a:xfrm>
            <a:off x="8814609" y="4872289"/>
            <a:ext cx="2526654" cy="1576226"/>
            <a:chOff x="9019538" y="4998413"/>
            <a:chExt cx="2526654" cy="1576226"/>
          </a:xfrm>
        </p:grpSpPr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9CF33C62-C80A-17CC-2ABA-F8B9C62A96EA}"/>
                </a:ext>
              </a:extLst>
            </p:cNvPr>
            <p:cNvGrpSpPr/>
            <p:nvPr/>
          </p:nvGrpSpPr>
          <p:grpSpPr>
            <a:xfrm>
              <a:off x="9019538" y="4998413"/>
              <a:ext cx="2526654" cy="787144"/>
              <a:chOff x="9552163" y="5078195"/>
              <a:chExt cx="2526654" cy="787144"/>
            </a:xfrm>
          </p:grpSpPr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EFDFA0C4-C429-EA14-8E62-E9148380262D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940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1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72B28AC4-2796-9700-8402-338B87421BEF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6654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2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NC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>
              <a:extLst>
                <a:ext uri="{FF2B5EF4-FFF2-40B4-BE49-F238E27FC236}">
                  <a16:creationId xmlns:a16="http://schemas.microsoft.com/office/drawing/2014/main" id="{475642DE-D767-6F06-72A5-7D9830658691}"/>
                </a:ext>
              </a:extLst>
            </p:cNvPr>
            <p:cNvGrpSpPr/>
            <p:nvPr/>
          </p:nvGrpSpPr>
          <p:grpSpPr>
            <a:xfrm>
              <a:off x="9019538" y="5787495"/>
              <a:ext cx="2525050" cy="787144"/>
              <a:chOff x="9552163" y="5078195"/>
              <a:chExt cx="2525050" cy="787144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1EAF443F-BF74-0B39-0187-D3F3D2E40AB3}"/>
                  </a:ext>
                </a:extLst>
              </p:cNvPr>
              <p:cNvSpPr txBox="1"/>
              <p:nvPr/>
            </p:nvSpPr>
            <p:spPr>
              <a:xfrm>
                <a:off x="9552163" y="5078195"/>
                <a:ext cx="24978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circ-EV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C6D8E860-42A7-F179-3F0A-6A9A300BC801}"/>
                  </a:ext>
                </a:extLst>
              </p:cNvPr>
              <p:cNvSpPr txBox="1"/>
              <p:nvPr/>
            </p:nvSpPr>
            <p:spPr>
              <a:xfrm>
                <a:off x="9552163" y="5465229"/>
                <a:ext cx="252505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4.</a:t>
                </a:r>
                <a:r>
                  <a:rPr kumimoji="1" lang="zh-CN" alt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circ-OE + </a:t>
                </a:r>
                <a:r>
                  <a:rPr kumimoji="1" lang="en-US" altLang="zh-CN" sz="2000" dirty="0" err="1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miR</a:t>
                </a:r>
                <a:r>
                  <a:rPr kumimoji="1" lang="en-US" altLang="zh-CN" sz="2000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-OE</a:t>
                </a:r>
                <a:endParaRPr kumimoji="1" lang="zh-CN" alt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35" name="直线连接符 34">
            <a:extLst>
              <a:ext uri="{FF2B5EF4-FFF2-40B4-BE49-F238E27FC236}">
                <a16:creationId xmlns:a16="http://schemas.microsoft.com/office/drawing/2014/main" id="{82768979-3565-2452-0089-6BAA31B2D601}"/>
              </a:ext>
            </a:extLst>
          </p:cNvPr>
          <p:cNvCxnSpPr>
            <a:cxnSpLocks/>
          </p:cNvCxnSpPr>
          <p:nvPr/>
        </p:nvCxnSpPr>
        <p:spPr>
          <a:xfrm>
            <a:off x="2061189" y="2401293"/>
            <a:ext cx="1122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7591088E-95CE-1C4A-7A04-F7E950CB7F27}"/>
              </a:ext>
            </a:extLst>
          </p:cNvPr>
          <p:cNvSpPr txBox="1"/>
          <p:nvPr/>
        </p:nvSpPr>
        <p:spPr>
          <a:xfrm>
            <a:off x="1643545" y="2239664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4413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1</TotalTime>
  <Words>394</Words>
  <Application>Microsoft Macintosh PowerPoint</Application>
  <PresentationFormat>宽屏</PresentationFormat>
  <Paragraphs>210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lei sui</dc:creator>
  <cp:lastModifiedBy>silei sui</cp:lastModifiedBy>
  <cp:revision>48</cp:revision>
  <dcterms:created xsi:type="dcterms:W3CDTF">2025-04-21T06:58:46Z</dcterms:created>
  <dcterms:modified xsi:type="dcterms:W3CDTF">2025-07-26T23:38:32Z</dcterms:modified>
</cp:coreProperties>
</file>